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7"/>
  </p:notesMasterIdLst>
  <p:sldIdLst>
    <p:sldId id="290" r:id="rId2"/>
    <p:sldId id="291" r:id="rId3"/>
    <p:sldId id="292" r:id="rId4"/>
    <p:sldId id="293" r:id="rId5"/>
    <p:sldId id="294" r:id="rId6"/>
  </p:sldIdLst>
  <p:sldSz cx="9144000" cy="6858000" type="screen4x3"/>
  <p:notesSz cx="6797675" cy="9928225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ovarik" initials="AK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řední styl 2 – zvýraznění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63" autoAdjust="0"/>
    <p:restoredTop sz="95461" autoAdjust="0"/>
  </p:normalViewPr>
  <p:slideViewPr>
    <p:cSldViewPr>
      <p:cViewPr varScale="1">
        <p:scale>
          <a:sx n="108" d="100"/>
          <a:sy n="108" d="100"/>
        </p:scale>
        <p:origin x="-78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8928C6-D35F-41D6-AEB9-0CC8CD36DBC5}" type="datetimeFigureOut">
              <a:rPr lang="cs-CZ" smtClean="0"/>
              <a:pPr/>
              <a:t>15.1.2020</a:t>
            </a:fld>
            <a:endParaRPr lang="cs-CZ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ep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696738-3A9E-4DE8-9324-37A3DEAF9F02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32513846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1EA9F-2DA5-4E5E-AADB-90629639A552}" type="datetime1">
              <a:rPr lang="cs-CZ" smtClean="0"/>
              <a:t>15.1.2020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F5404-1A97-4946-AED3-F51574ED3915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451159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7B533-68AD-4843-B29D-5243435F6F9F}" type="datetime1">
              <a:rPr lang="cs-CZ" smtClean="0"/>
              <a:t>15.1.2020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F5404-1A97-4946-AED3-F51574ED3915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33389886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315F5-A156-4BE7-B0E9-5F00920E702E}" type="datetime1">
              <a:rPr lang="cs-CZ" smtClean="0"/>
              <a:t>15.1.2020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F5404-1A97-4946-AED3-F51574ED3915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13063149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56DEF-C12B-456A-BD0D-00F624A038D6}" type="datetime1">
              <a:rPr lang="cs-CZ" smtClean="0"/>
              <a:t>15.1.2020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F5404-1A97-4946-AED3-F51574ED3915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3003867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EEFE1-5D97-4D30-B3BC-E10B684E9AE1}" type="datetime1">
              <a:rPr lang="cs-CZ" smtClean="0"/>
              <a:t>15.1.2020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F5404-1A97-4946-AED3-F51574ED3915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4800117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F4849-095D-458C-9884-9D82DA607B8E}" type="datetime1">
              <a:rPr lang="cs-CZ" smtClean="0"/>
              <a:t>15.1.2020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F5404-1A97-4946-AED3-F51574ED3915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2302324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F039B-C896-4517-8029-9DD2A972A8A5}" type="datetime1">
              <a:rPr lang="cs-CZ" smtClean="0"/>
              <a:t>15.1.2020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F5404-1A97-4946-AED3-F51574ED3915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12752826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33D9D-F0BC-4247-8A65-BFA760D0E7D7}" type="datetime1">
              <a:rPr lang="cs-CZ" smtClean="0"/>
              <a:t>15.1.2020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F5404-1A97-4946-AED3-F51574ED3915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29700738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64B770-A2EC-47D8-A755-B9288DA019E5}" type="datetime1">
              <a:rPr lang="cs-CZ" smtClean="0"/>
              <a:t>15.1.2020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F5404-1A97-4946-AED3-F51574ED3915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30940082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7A25D-AD8F-4844-9D09-0CD98B1C235E}" type="datetime1">
              <a:rPr lang="cs-CZ" smtClean="0"/>
              <a:t>15.1.2020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F5404-1A97-4946-AED3-F51574ED3915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320323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8D7AE-2E12-4B9A-95CD-32A976CBB450}" type="datetime1">
              <a:rPr lang="cs-CZ" smtClean="0"/>
              <a:t>15.1.2020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F5404-1A97-4946-AED3-F51574ED3915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2985001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D535F1-AAFF-4E86-9BF8-8F24D37DCAFC}" type="datetime1">
              <a:rPr lang="cs-CZ" smtClean="0"/>
              <a:t>15.1.2020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5F5404-1A97-4946-AED3-F51574ED3915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1031967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hdphoto" Target="../media/hdphoto1.wdp"/><Relationship Id="rId7" Type="http://schemas.openxmlformats.org/officeDocument/2006/relationships/image" Target="../media/image4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tiff"/><Relationship Id="rId5" Type="http://schemas.microsoft.com/office/2007/relationships/hdphoto" Target="../media/hdphoto2.wdp"/><Relationship Id="rId10" Type="http://schemas.openxmlformats.org/officeDocument/2006/relationships/image" Target="../media/image6.tiff"/><Relationship Id="rId4" Type="http://schemas.openxmlformats.org/officeDocument/2006/relationships/image" Target="../media/image2.png"/><Relationship Id="rId9" Type="http://schemas.microsoft.com/office/2007/relationships/hdphoto" Target="../media/hdphoto3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microsoft.com/office/2007/relationships/hdphoto" Target="../media/hdphoto4.wdp"/><Relationship Id="rId7" Type="http://schemas.openxmlformats.org/officeDocument/2006/relationships/image" Target="../media/image10.tiff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microsoft.com/office/2007/relationships/hdphoto" Target="../media/hdphoto5.wdp"/><Relationship Id="rId5" Type="http://schemas.openxmlformats.org/officeDocument/2006/relationships/image" Target="../media/image9.png"/><Relationship Id="rId10" Type="http://schemas.openxmlformats.org/officeDocument/2006/relationships/image" Target="../media/image12.tiff"/><Relationship Id="rId4" Type="http://schemas.openxmlformats.org/officeDocument/2006/relationships/image" Target="../media/image8.tiff"/><Relationship Id="rId9" Type="http://schemas.microsoft.com/office/2007/relationships/hdphoto" Target="../media/hdphoto6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tiff"/><Relationship Id="rId3" Type="http://schemas.microsoft.com/office/2007/relationships/hdphoto" Target="../media/hdphoto7.wdp"/><Relationship Id="rId7" Type="http://schemas.openxmlformats.org/officeDocument/2006/relationships/image" Target="../media/image16.tiff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microsoft.com/office/2007/relationships/hdphoto" Target="../media/hdphoto8.wdp"/><Relationship Id="rId5" Type="http://schemas.openxmlformats.org/officeDocument/2006/relationships/image" Target="../media/image15.png"/><Relationship Id="rId10" Type="http://schemas.microsoft.com/office/2007/relationships/hdphoto" Target="../media/hdphoto9.wdp"/><Relationship Id="rId4" Type="http://schemas.openxmlformats.org/officeDocument/2006/relationships/image" Target="../media/image14.tiff"/><Relationship Id="rId9" Type="http://schemas.openxmlformats.org/officeDocument/2006/relationships/image" Target="../media/image1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microsoft.com/office/2007/relationships/hdphoto" Target="../media/hdphoto10.wdp"/><Relationship Id="rId7" Type="http://schemas.microsoft.com/office/2007/relationships/hdphoto" Target="../media/hdphoto11.wdp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tiff"/><Relationship Id="rId10" Type="http://schemas.openxmlformats.org/officeDocument/2006/relationships/image" Target="../media/image24.tiff"/><Relationship Id="rId4" Type="http://schemas.openxmlformats.org/officeDocument/2006/relationships/image" Target="../media/image20.tiff"/><Relationship Id="rId9" Type="http://schemas.microsoft.com/office/2007/relationships/hdphoto" Target="../media/hdphoto12.wd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microsoft.com/office/2007/relationships/hdphoto" Target="../media/hdphoto13.wdp"/><Relationship Id="rId7" Type="http://schemas.microsoft.com/office/2007/relationships/hdphoto" Target="../media/hdphoto15.wdp"/><Relationship Id="rId12" Type="http://schemas.microsoft.com/office/2007/relationships/hdphoto" Target="../media/hdphoto17.wdp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11" Type="http://schemas.openxmlformats.org/officeDocument/2006/relationships/image" Target="../media/image30.png"/><Relationship Id="rId5" Type="http://schemas.microsoft.com/office/2007/relationships/hdphoto" Target="../media/hdphoto14.wdp"/><Relationship Id="rId10" Type="http://schemas.openxmlformats.org/officeDocument/2006/relationships/image" Target="../media/image29.tiff"/><Relationship Id="rId4" Type="http://schemas.openxmlformats.org/officeDocument/2006/relationships/image" Target="../media/image26.png"/><Relationship Id="rId9" Type="http://schemas.microsoft.com/office/2007/relationships/hdphoto" Target="../media/hdphoto1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ovéPole 20"/>
          <p:cNvSpPr txBox="1"/>
          <p:nvPr/>
        </p:nvSpPr>
        <p:spPr>
          <a:xfrm>
            <a:off x="171956" y="994973"/>
            <a:ext cx="16273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R</a:t>
            </a:r>
            <a:r>
              <a:rPr lang="cs-CZ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cs-CZ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nina</a:t>
            </a:r>
            <a:r>
              <a:rPr lang="cs-CZ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Z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1</a:t>
            </a:r>
            <a:endParaRPr lang="cs-CZ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Skupina 1"/>
          <p:cNvGrpSpPr/>
          <p:nvPr/>
        </p:nvGrpSpPr>
        <p:grpSpPr>
          <a:xfrm>
            <a:off x="67158" y="1340768"/>
            <a:ext cx="8798060" cy="5416298"/>
            <a:chOff x="360720" y="1037039"/>
            <a:chExt cx="8378513" cy="4876304"/>
          </a:xfrm>
        </p:grpSpPr>
        <p:sp>
          <p:nvSpPr>
            <p:cNvPr id="5" name="TextovéPole 4"/>
            <p:cNvSpPr txBox="1"/>
            <p:nvPr/>
          </p:nvSpPr>
          <p:spPr>
            <a:xfrm>
              <a:off x="1207354" y="1037039"/>
              <a:ext cx="9541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900" dirty="0"/>
                <a:t>R. canina_CZ_16</a:t>
              </a:r>
            </a:p>
          </p:txBody>
        </p:sp>
        <p:sp>
          <p:nvSpPr>
            <p:cNvPr id="22" name="TextovéPole 21"/>
            <p:cNvSpPr txBox="1"/>
            <p:nvPr/>
          </p:nvSpPr>
          <p:spPr>
            <a:xfrm>
              <a:off x="4245832" y="1045106"/>
              <a:ext cx="9541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900" dirty="0"/>
                <a:t>R. canina_CZ_22</a:t>
              </a:r>
            </a:p>
          </p:txBody>
        </p:sp>
        <p:grpSp>
          <p:nvGrpSpPr>
            <p:cNvPr id="49" name="Skupina 48"/>
            <p:cNvGrpSpPr/>
            <p:nvPr/>
          </p:nvGrpSpPr>
          <p:grpSpPr>
            <a:xfrm>
              <a:off x="579952" y="1212514"/>
              <a:ext cx="2562157" cy="2502236"/>
              <a:chOff x="625800" y="473685"/>
              <a:chExt cx="3757088" cy="3746474"/>
            </a:xfrm>
          </p:grpSpPr>
          <p:pic>
            <p:nvPicPr>
              <p:cNvPr id="7" name="Obrázek 6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 xmlns="">
                      <a14:imgLayer r:embed="rId3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25709" t="24157" r="26162" b="20470"/>
              <a:stretch/>
            </p:blipFill>
            <p:spPr>
              <a:xfrm>
                <a:off x="625800" y="473685"/>
                <a:ext cx="3757088" cy="3746474"/>
              </a:xfrm>
              <a:prstGeom prst="rect">
                <a:avLst/>
              </a:prstGeom>
            </p:spPr>
          </p:pic>
          <p:cxnSp>
            <p:nvCxnSpPr>
              <p:cNvPr id="6" name="Přímá spojnice se šipkou 5"/>
              <p:cNvCxnSpPr/>
              <p:nvPr/>
            </p:nvCxnSpPr>
            <p:spPr>
              <a:xfrm flipH="1">
                <a:off x="3151969" y="1347157"/>
                <a:ext cx="75304" cy="107576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Přímá spojnice se šipkou 26"/>
              <p:cNvCxnSpPr/>
              <p:nvPr/>
            </p:nvCxnSpPr>
            <p:spPr>
              <a:xfrm flipH="1">
                <a:off x="3114317" y="1954527"/>
                <a:ext cx="75304" cy="107576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Přímá spojnice se šipkou 27"/>
              <p:cNvCxnSpPr/>
              <p:nvPr/>
            </p:nvCxnSpPr>
            <p:spPr>
              <a:xfrm flipH="1">
                <a:off x="2512895" y="3172984"/>
                <a:ext cx="75304" cy="107576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Přímá spojnice se šipkou 28"/>
              <p:cNvCxnSpPr/>
              <p:nvPr/>
            </p:nvCxnSpPr>
            <p:spPr>
              <a:xfrm flipH="1">
                <a:off x="1911473" y="2990848"/>
                <a:ext cx="75304" cy="107576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Přímá spojnice se šipkou 29"/>
              <p:cNvCxnSpPr/>
              <p:nvPr/>
            </p:nvCxnSpPr>
            <p:spPr>
              <a:xfrm flipH="1">
                <a:off x="1540529" y="2937060"/>
                <a:ext cx="75304" cy="107576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Přímá spojnice se šipkou 30"/>
              <p:cNvCxnSpPr/>
              <p:nvPr/>
            </p:nvCxnSpPr>
            <p:spPr>
              <a:xfrm flipH="1">
                <a:off x="2072667" y="2128486"/>
                <a:ext cx="75304" cy="107576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Přímá spojnice se šipkou 31"/>
              <p:cNvCxnSpPr/>
              <p:nvPr/>
            </p:nvCxnSpPr>
            <p:spPr>
              <a:xfrm flipH="1">
                <a:off x="1301746" y="1954527"/>
                <a:ext cx="75304" cy="107576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0" name="Skupina 49"/>
            <p:cNvGrpSpPr/>
            <p:nvPr/>
          </p:nvGrpSpPr>
          <p:grpSpPr>
            <a:xfrm>
              <a:off x="3492809" y="1221298"/>
              <a:ext cx="2430869" cy="2483060"/>
              <a:chOff x="4490820" y="499252"/>
              <a:chExt cx="3686944" cy="3735456"/>
            </a:xfrm>
          </p:grpSpPr>
          <p:pic>
            <p:nvPicPr>
              <p:cNvPr id="33" name="Obrázek 32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 xmlns="">
                      <a14:imgLayer r:embed="rId5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21001" t="15431" r="23634" b="19850"/>
              <a:stretch/>
            </p:blipFill>
            <p:spPr>
              <a:xfrm>
                <a:off x="4490820" y="499252"/>
                <a:ext cx="3686944" cy="3735456"/>
              </a:xfrm>
              <a:prstGeom prst="rect">
                <a:avLst/>
              </a:prstGeom>
            </p:spPr>
          </p:pic>
          <p:cxnSp>
            <p:nvCxnSpPr>
              <p:cNvPr id="34" name="Přímá spojnice se šipkou 33"/>
              <p:cNvCxnSpPr/>
              <p:nvPr/>
            </p:nvCxnSpPr>
            <p:spPr>
              <a:xfrm flipH="1">
                <a:off x="5985224" y="1182635"/>
                <a:ext cx="75304" cy="107576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Přímá spojnice se šipkou 34"/>
              <p:cNvCxnSpPr/>
              <p:nvPr/>
            </p:nvCxnSpPr>
            <p:spPr>
              <a:xfrm flipH="1">
                <a:off x="5527764" y="1400945"/>
                <a:ext cx="75304" cy="107576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Přímá spojnice se šipkou 35"/>
              <p:cNvCxnSpPr/>
              <p:nvPr/>
            </p:nvCxnSpPr>
            <p:spPr>
              <a:xfrm flipH="1">
                <a:off x="5175071" y="1454733"/>
                <a:ext cx="75304" cy="107576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Přímá spojnice se šipkou 36"/>
              <p:cNvCxnSpPr/>
              <p:nvPr/>
            </p:nvCxnSpPr>
            <p:spPr>
              <a:xfrm flipH="1">
                <a:off x="5565416" y="2656615"/>
                <a:ext cx="75304" cy="107576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Přímá spojnice se šipkou 37"/>
              <p:cNvCxnSpPr/>
              <p:nvPr/>
            </p:nvCxnSpPr>
            <p:spPr>
              <a:xfrm flipH="1">
                <a:off x="6720594" y="2074698"/>
                <a:ext cx="75304" cy="107576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Přímá spojnice se šipkou 38"/>
              <p:cNvCxnSpPr/>
              <p:nvPr/>
            </p:nvCxnSpPr>
            <p:spPr>
              <a:xfrm flipH="1">
                <a:off x="6334292" y="2710403"/>
                <a:ext cx="75304" cy="107576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Přímá spojnice se šipkou 39"/>
              <p:cNvCxnSpPr/>
              <p:nvPr/>
            </p:nvCxnSpPr>
            <p:spPr>
              <a:xfrm flipH="1">
                <a:off x="7650474" y="2313192"/>
                <a:ext cx="75304" cy="107576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9" name="Skupina 78"/>
            <p:cNvGrpSpPr/>
            <p:nvPr/>
          </p:nvGrpSpPr>
          <p:grpSpPr>
            <a:xfrm>
              <a:off x="360720" y="3747913"/>
              <a:ext cx="2640151" cy="2144125"/>
              <a:chOff x="480959" y="3854217"/>
              <a:chExt cx="3520201" cy="2858833"/>
            </a:xfrm>
          </p:grpSpPr>
          <p:pic>
            <p:nvPicPr>
              <p:cNvPr id="52" name="Obrázek 51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24786" t="26076" r="23363" b="25339"/>
              <a:stretch/>
            </p:blipFill>
            <p:spPr>
              <a:xfrm>
                <a:off x="480959" y="3854217"/>
                <a:ext cx="3520201" cy="2858833"/>
              </a:xfrm>
              <a:prstGeom prst="rect">
                <a:avLst/>
              </a:prstGeom>
            </p:spPr>
          </p:pic>
          <p:cxnSp>
            <p:nvCxnSpPr>
              <p:cNvPr id="56" name="Přímá spojnice se šipkou 55"/>
              <p:cNvCxnSpPr/>
              <p:nvPr/>
            </p:nvCxnSpPr>
            <p:spPr>
              <a:xfrm flipH="1">
                <a:off x="3152775" y="4543425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Přímá spojnice se šipkou 56"/>
              <p:cNvCxnSpPr/>
              <p:nvPr/>
            </p:nvCxnSpPr>
            <p:spPr>
              <a:xfrm flipH="1">
                <a:off x="3105150" y="5076825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Přímá spojnice se šipkou 57"/>
              <p:cNvCxnSpPr/>
              <p:nvPr/>
            </p:nvCxnSpPr>
            <p:spPr>
              <a:xfrm flipH="1">
                <a:off x="2590800" y="6115050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Přímá spojnice se šipkou 58"/>
              <p:cNvCxnSpPr/>
              <p:nvPr/>
            </p:nvCxnSpPr>
            <p:spPr>
              <a:xfrm flipH="1">
                <a:off x="2085975" y="5981700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Přímá spojnice se šipkou 59"/>
              <p:cNvCxnSpPr/>
              <p:nvPr/>
            </p:nvCxnSpPr>
            <p:spPr>
              <a:xfrm flipH="1">
                <a:off x="1752600" y="5915025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Přímá spojnice se šipkou 60"/>
              <p:cNvCxnSpPr/>
              <p:nvPr/>
            </p:nvCxnSpPr>
            <p:spPr>
              <a:xfrm flipH="1">
                <a:off x="1543050" y="5067300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Přímá spojnice se šipkou 61"/>
              <p:cNvCxnSpPr/>
              <p:nvPr/>
            </p:nvCxnSpPr>
            <p:spPr>
              <a:xfrm flipH="1">
                <a:off x="2190750" y="5229225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8" name="Skupina 77"/>
            <p:cNvGrpSpPr/>
            <p:nvPr/>
          </p:nvGrpSpPr>
          <p:grpSpPr>
            <a:xfrm>
              <a:off x="3492809" y="3809861"/>
              <a:ext cx="2389555" cy="2103482"/>
              <a:chOff x="4657078" y="3936815"/>
              <a:chExt cx="3186073" cy="2804642"/>
            </a:xfrm>
          </p:grpSpPr>
          <p:pic>
            <p:nvPicPr>
              <p:cNvPr id="53" name="Obrázek 52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21738" t="19632" r="24845" b="26116"/>
              <a:stretch/>
            </p:blipFill>
            <p:spPr>
              <a:xfrm>
                <a:off x="4657078" y="3936815"/>
                <a:ext cx="3186073" cy="2804642"/>
              </a:xfrm>
              <a:prstGeom prst="rect">
                <a:avLst/>
              </a:prstGeom>
            </p:spPr>
          </p:pic>
          <p:cxnSp>
            <p:nvCxnSpPr>
              <p:cNvPr id="63" name="Přímá spojnice se šipkou 62"/>
              <p:cNvCxnSpPr/>
              <p:nvPr/>
            </p:nvCxnSpPr>
            <p:spPr>
              <a:xfrm flipH="1">
                <a:off x="5886450" y="4314825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Přímá spojnice se šipkou 63"/>
              <p:cNvCxnSpPr/>
              <p:nvPr/>
            </p:nvCxnSpPr>
            <p:spPr>
              <a:xfrm flipH="1">
                <a:off x="5181600" y="4543425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Přímá spojnice se šipkou 64"/>
              <p:cNvCxnSpPr/>
              <p:nvPr/>
            </p:nvCxnSpPr>
            <p:spPr>
              <a:xfrm flipH="1">
                <a:off x="5543550" y="4505325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Přímá spojnice se šipkou 65"/>
              <p:cNvCxnSpPr/>
              <p:nvPr/>
            </p:nvCxnSpPr>
            <p:spPr>
              <a:xfrm flipH="1">
                <a:off x="5524500" y="5638800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Přímá spojnice se šipkou 66"/>
              <p:cNvCxnSpPr/>
              <p:nvPr/>
            </p:nvCxnSpPr>
            <p:spPr>
              <a:xfrm flipH="1">
                <a:off x="6257925" y="5705475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Přímá spojnice se šipkou 67"/>
              <p:cNvCxnSpPr/>
              <p:nvPr/>
            </p:nvCxnSpPr>
            <p:spPr>
              <a:xfrm flipH="1">
                <a:off x="6591300" y="5124450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Přímá spojnice se šipkou 68"/>
              <p:cNvCxnSpPr/>
              <p:nvPr/>
            </p:nvCxnSpPr>
            <p:spPr>
              <a:xfrm flipH="1">
                <a:off x="7448550" y="5324475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7" name="Skupina 76"/>
            <p:cNvGrpSpPr/>
            <p:nvPr/>
          </p:nvGrpSpPr>
          <p:grpSpPr>
            <a:xfrm>
              <a:off x="6227949" y="1054863"/>
              <a:ext cx="2511284" cy="4839266"/>
              <a:chOff x="8303931" y="263484"/>
              <a:chExt cx="3348378" cy="6452354"/>
            </a:xfrm>
          </p:grpSpPr>
          <p:sp>
            <p:nvSpPr>
              <p:cNvPr id="23" name="TextovéPole 22"/>
              <p:cNvSpPr txBox="1"/>
              <p:nvPr/>
            </p:nvSpPr>
            <p:spPr>
              <a:xfrm>
                <a:off x="9523598" y="263484"/>
                <a:ext cx="1272142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900" dirty="0"/>
                  <a:t>R. canina_CZ_20</a:t>
                </a:r>
              </a:p>
            </p:txBody>
          </p:sp>
          <p:grpSp>
            <p:nvGrpSpPr>
              <p:cNvPr id="51" name="Skupina 50"/>
              <p:cNvGrpSpPr/>
              <p:nvPr/>
            </p:nvGrpSpPr>
            <p:grpSpPr>
              <a:xfrm>
                <a:off x="8303931" y="499252"/>
                <a:ext cx="3348378" cy="3310747"/>
                <a:chOff x="8297879" y="499252"/>
                <a:chExt cx="3446180" cy="3695340"/>
              </a:xfrm>
            </p:grpSpPr>
            <p:pic>
              <p:nvPicPr>
                <p:cNvPr id="17" name="Obrázek 16"/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extLst>
                    <a:ext uri="{BEBA8EAE-BF5A-486C-A8C5-ECC9F3942E4B}">
                      <a14:imgProps xmlns:a14="http://schemas.microsoft.com/office/drawing/2010/main" xmlns="">
                        <a14:imgLayer r:embed="rId9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21223" t="17097" r="23035" b="13938"/>
                <a:stretch/>
              </p:blipFill>
              <p:spPr>
                <a:xfrm>
                  <a:off x="8297879" y="499252"/>
                  <a:ext cx="3446180" cy="3695340"/>
                </a:xfrm>
                <a:prstGeom prst="rect">
                  <a:avLst/>
                </a:prstGeom>
              </p:spPr>
            </p:pic>
            <p:cxnSp>
              <p:nvCxnSpPr>
                <p:cNvPr id="41" name="Přímá spojnice se šipkou 40"/>
                <p:cNvCxnSpPr/>
                <p:nvPr/>
              </p:nvCxnSpPr>
              <p:spPr>
                <a:xfrm flipH="1">
                  <a:off x="10304027" y="1075059"/>
                  <a:ext cx="75304" cy="107576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Přímá spojnice se šipkou 41"/>
                <p:cNvCxnSpPr/>
                <p:nvPr/>
              </p:nvCxnSpPr>
              <p:spPr>
                <a:xfrm flipH="1">
                  <a:off x="9461343" y="1825855"/>
                  <a:ext cx="75304" cy="107576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Přímá spojnice se šipkou 42"/>
                <p:cNvCxnSpPr/>
                <p:nvPr/>
              </p:nvCxnSpPr>
              <p:spPr>
                <a:xfrm flipH="1">
                  <a:off x="9887645" y="2074698"/>
                  <a:ext cx="75304" cy="107576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Přímá spojnice se šipkou 43"/>
                <p:cNvCxnSpPr/>
                <p:nvPr/>
              </p:nvCxnSpPr>
              <p:spPr>
                <a:xfrm flipH="1">
                  <a:off x="9536647" y="2829484"/>
                  <a:ext cx="75304" cy="107576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Přímá spojnice se šipkou 44"/>
                <p:cNvCxnSpPr/>
                <p:nvPr/>
              </p:nvCxnSpPr>
              <p:spPr>
                <a:xfrm flipH="1">
                  <a:off x="10234203" y="3197945"/>
                  <a:ext cx="75304" cy="107576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Přímá spojnice se šipkou 45"/>
                <p:cNvCxnSpPr/>
                <p:nvPr/>
              </p:nvCxnSpPr>
              <p:spPr>
                <a:xfrm flipH="1">
                  <a:off x="10877421" y="3119196"/>
                  <a:ext cx="75304" cy="107576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Přímá spojnice se šipkou 46"/>
                <p:cNvCxnSpPr/>
                <p:nvPr/>
              </p:nvCxnSpPr>
              <p:spPr>
                <a:xfrm flipH="1">
                  <a:off x="10077321" y="3044636"/>
                  <a:ext cx="75304" cy="107576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54" name="Obrázek 53"/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21809" t="17172" r="23385" b="23232"/>
              <a:stretch/>
            </p:blipFill>
            <p:spPr>
              <a:xfrm>
                <a:off x="8560712" y="3871882"/>
                <a:ext cx="3017486" cy="2843956"/>
              </a:xfrm>
              <a:prstGeom prst="rect">
                <a:avLst/>
              </a:prstGeom>
            </p:spPr>
          </p:pic>
          <p:cxnSp>
            <p:nvCxnSpPr>
              <p:cNvPr id="70" name="Přímá spojnice se šipkou 69"/>
              <p:cNvCxnSpPr/>
              <p:nvPr/>
            </p:nvCxnSpPr>
            <p:spPr>
              <a:xfrm flipH="1">
                <a:off x="9401175" y="4686300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Přímá spojnice se šipkou 70"/>
              <p:cNvCxnSpPr/>
              <p:nvPr/>
            </p:nvCxnSpPr>
            <p:spPr>
              <a:xfrm flipH="1">
                <a:off x="9772650" y="4895850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Přímá spojnice se šipkou 71"/>
              <p:cNvCxnSpPr/>
              <p:nvPr/>
            </p:nvCxnSpPr>
            <p:spPr>
              <a:xfrm flipH="1">
                <a:off x="10144125" y="4010025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Přímá spojnice se šipkou 72"/>
              <p:cNvCxnSpPr/>
              <p:nvPr/>
            </p:nvCxnSpPr>
            <p:spPr>
              <a:xfrm flipH="1">
                <a:off x="9934575" y="5734050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Přímá spojnice se šipkou 73"/>
              <p:cNvCxnSpPr/>
              <p:nvPr/>
            </p:nvCxnSpPr>
            <p:spPr>
              <a:xfrm flipH="1">
                <a:off x="10086975" y="5886450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Přímá spojnice se šipkou 74"/>
              <p:cNvCxnSpPr/>
              <p:nvPr/>
            </p:nvCxnSpPr>
            <p:spPr>
              <a:xfrm flipH="1">
                <a:off x="10639425" y="5838825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Přímá spojnice se šipkou 75"/>
              <p:cNvCxnSpPr/>
              <p:nvPr/>
            </p:nvCxnSpPr>
            <p:spPr>
              <a:xfrm flipH="1">
                <a:off x="9429750" y="5581650"/>
                <a:ext cx="38100" cy="1143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179512" y="77723"/>
            <a:ext cx="8613699" cy="830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cs-CZ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S3. </a:t>
            </a:r>
            <a:r>
              <a:rPr kumimoji="0" lang="en-GB" altLang="cs-CZ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SH analysis of additional meiotic nuclei of </a:t>
            </a:r>
            <a:r>
              <a:rPr kumimoji="0" lang="en-GB" altLang="cs-CZ" sz="1200" b="0" i="0" u="none" strike="noStrike" cap="none" normalizeH="0" baseline="0" dirty="0" err="1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lyploid</a:t>
            </a:r>
            <a:r>
              <a:rPr kumimoji="0" lang="en-GB" altLang="cs-CZ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GB" altLang="cs-CZ" sz="1200" b="0" i="0" u="none" strike="noStrike" cap="none" normalizeH="0" baseline="0" dirty="0" err="1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groses</a:t>
            </a:r>
            <a:r>
              <a:rPr kumimoji="0" lang="en-GB" altLang="cs-CZ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FISH with</a:t>
            </a:r>
            <a:r>
              <a:rPr kumimoji="0" lang="en-GB" altLang="cs-CZ" sz="1200" b="0" i="0" u="sng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GB" altLang="cs-CZ" sz="1200" b="0" i="0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kumimoji="0" lang="en-GB" altLang="cs-CZ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ANR4 satellite (red) and 18S rDNA (green, for </a:t>
            </a:r>
            <a:r>
              <a:rPr kumimoji="0" lang="en-GB" altLang="cs-CZ" sz="1200" b="0" i="1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. </a:t>
            </a:r>
            <a:r>
              <a:rPr kumimoji="0" lang="en-GB" altLang="cs-CZ" sz="1200" b="0" i="1" u="none" strike="noStrike" cap="none" normalizeH="0" baseline="0" dirty="0" err="1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ubiginosa</a:t>
            </a:r>
            <a:r>
              <a:rPr kumimoji="0" lang="en-GB" altLang="cs-CZ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nly). (A) </a:t>
            </a:r>
            <a:r>
              <a:rPr kumimoji="0" lang="en-GB" altLang="cs-CZ" sz="1200" b="0" i="1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. </a:t>
            </a:r>
            <a:r>
              <a:rPr lang="cs-CZ" altLang="cs-CZ" sz="12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0" lang="en-GB" altLang="cs-CZ" sz="1200" b="0" i="1" u="none" strike="noStrike" cap="none" normalizeH="0" baseline="0" dirty="0" err="1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ina</a:t>
            </a:r>
            <a:r>
              <a:rPr kumimoji="0" lang="en-GB" altLang="cs-CZ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Z </a:t>
            </a:r>
            <a:r>
              <a:rPr kumimoji="0" lang="en-GB" altLang="cs-CZ" sz="1200" b="0" i="0" u="none" strike="noStrike" cap="none" normalizeH="0" baseline="0" dirty="0" err="1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.</a:t>
            </a:r>
            <a:r>
              <a:rPr kumimoji="0" lang="en-GB" altLang="cs-CZ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, (B) </a:t>
            </a:r>
            <a:r>
              <a:rPr kumimoji="0" lang="en-GB" altLang="cs-CZ" sz="1200" b="0" i="1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. </a:t>
            </a:r>
            <a:r>
              <a:rPr kumimoji="0" lang="en-GB" altLang="cs-CZ" sz="1200" b="0" i="1" u="none" strike="noStrike" cap="none" normalizeH="0" baseline="0" dirty="0" err="1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nina</a:t>
            </a:r>
            <a:r>
              <a:rPr kumimoji="0" lang="en-GB" altLang="cs-CZ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Z </a:t>
            </a:r>
            <a:r>
              <a:rPr kumimoji="0" lang="en-GB" altLang="cs-CZ" sz="1200" b="0" i="0" u="none" strike="noStrike" cap="none" normalizeH="0" baseline="0" dirty="0" err="1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.</a:t>
            </a:r>
            <a:r>
              <a:rPr kumimoji="0" lang="en-GB" altLang="cs-CZ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, (C) </a:t>
            </a:r>
            <a:r>
              <a:rPr kumimoji="0" lang="en-GB" altLang="cs-CZ" sz="1200" b="0" i="1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. </a:t>
            </a:r>
            <a:r>
              <a:rPr kumimoji="0" lang="en-GB" altLang="cs-CZ" sz="1200" b="0" i="1" u="none" strike="noStrike" cap="none" normalizeH="0" baseline="0" dirty="0" err="1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nina</a:t>
            </a:r>
            <a:r>
              <a:rPr lang="cs-CZ" altLang="cs-CZ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GB" altLang="cs-CZ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Z </a:t>
            </a:r>
            <a:r>
              <a:rPr kumimoji="0" lang="en-GB" altLang="cs-CZ" sz="1200" b="0" i="0" u="none" strike="noStrike" cap="none" normalizeH="0" baseline="0" dirty="0" err="1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.</a:t>
            </a:r>
            <a:r>
              <a:rPr kumimoji="0" lang="en-GB" altLang="cs-CZ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3, (D) </a:t>
            </a:r>
            <a:r>
              <a:rPr kumimoji="0" lang="en-GB" altLang="cs-CZ" sz="1200" b="0" i="1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. </a:t>
            </a:r>
            <a:r>
              <a:rPr kumimoji="0" lang="cs-CZ" altLang="cs-CZ" sz="1200" b="0" i="1" u="none" strike="noStrike" cap="none" normalizeH="0" baseline="0" dirty="0" err="1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odora</a:t>
            </a:r>
            <a:r>
              <a:rPr kumimoji="0" lang="en-GB" altLang="cs-CZ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(E) </a:t>
            </a:r>
            <a:r>
              <a:rPr kumimoji="0" lang="en-GB" altLang="cs-CZ" sz="1200" b="0" i="1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. </a:t>
            </a:r>
            <a:r>
              <a:rPr kumimoji="0" lang="en-GB" altLang="cs-CZ" sz="1200" b="0" i="1" u="none" strike="noStrike" cap="none" normalizeH="0" baseline="0" dirty="0" err="1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ubiginosa</a:t>
            </a:r>
            <a:r>
              <a:rPr kumimoji="0" lang="en-GB" altLang="cs-CZ" sz="1200" b="0" i="0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The</a:t>
            </a:r>
            <a:r>
              <a:rPr kumimoji="0" lang="en-GB" altLang="cs-CZ" sz="1200" b="0" i="0" u="sng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GB" altLang="cs-CZ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pper line represents FISH signals counterstained with DAPI</a:t>
            </a:r>
            <a:r>
              <a:rPr kumimoji="0" lang="en-GB" altLang="cs-CZ" sz="1200" b="0" i="0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the</a:t>
            </a:r>
            <a:r>
              <a:rPr kumimoji="0" lang="en-GB" altLang="cs-CZ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ottom line represents DAPI </a:t>
            </a:r>
            <a:r>
              <a:rPr kumimoji="0" lang="en-GB" altLang="cs-CZ" sz="1200" b="0" i="0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0" lang="en-GB" altLang="cs-CZ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verted grey scale</a:t>
            </a:r>
            <a:r>
              <a:rPr kumimoji="0" lang="en-GB" altLang="cs-CZ" sz="1200" b="0" i="0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r>
              <a:rPr kumimoji="0" lang="en-GB" altLang="cs-CZ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rrows indicate bivalent chromosomes.</a:t>
            </a:r>
            <a:r>
              <a:rPr kumimoji="0" lang="cs-CZ" altLang="cs-CZ" sz="6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0" lang="cs-CZ" altLang="cs-CZ" sz="1800" b="0" i="0" u="none" strike="noStrike" cap="none" normalizeH="0" baseline="0" dirty="0" smtClean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Zástupný symbol pro číslo snímku 79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F5404-1A97-4946-AED3-F51574ED3915}" type="slidenum">
              <a:rPr lang="cs-CZ" smtClean="0"/>
              <a:pPr/>
              <a:t>1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25094656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Skupina 5"/>
          <p:cNvGrpSpPr/>
          <p:nvPr/>
        </p:nvGrpSpPr>
        <p:grpSpPr>
          <a:xfrm>
            <a:off x="222055" y="752879"/>
            <a:ext cx="8670425" cy="5628449"/>
            <a:chOff x="357752" y="639460"/>
            <a:chExt cx="8431755" cy="5380006"/>
          </a:xfrm>
        </p:grpSpPr>
        <p:grpSp>
          <p:nvGrpSpPr>
            <p:cNvPr id="75" name="Skupina 74"/>
            <p:cNvGrpSpPr/>
            <p:nvPr/>
          </p:nvGrpSpPr>
          <p:grpSpPr>
            <a:xfrm>
              <a:off x="357752" y="639460"/>
              <a:ext cx="2732478" cy="5346956"/>
              <a:chOff x="477002" y="-290389"/>
              <a:chExt cx="3643305" cy="7129276"/>
            </a:xfrm>
          </p:grpSpPr>
          <p:sp>
            <p:nvSpPr>
              <p:cNvPr id="4" name="TextovéPole 3"/>
              <p:cNvSpPr txBox="1"/>
              <p:nvPr/>
            </p:nvSpPr>
            <p:spPr>
              <a:xfrm>
                <a:off x="477002" y="-290389"/>
                <a:ext cx="2162060" cy="3824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r>
                  <a:rPr lang="cs-CZ" sz="12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R</a:t>
                </a:r>
                <a:r>
                  <a:rPr lang="cs-CZ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cs-CZ" sz="1200" i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nina</a:t>
                </a:r>
                <a:r>
                  <a:rPr lang="cs-CZ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cs-CZ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Z </a:t>
                </a:r>
                <a:r>
                  <a:rPr lang="cs-CZ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d</a:t>
                </a:r>
                <a:r>
                  <a:rPr lang="cs-CZ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cs-CZ" sz="135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cs-CZ" sz="13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2" name="Obrázek 1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 xmlns="">
                      <a14:imgLayer r:embed="rId3">
                        <a14:imgEffect>
                          <a14:brightnessContrast bright="25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23082" t="23132" r="28327" b="24177"/>
              <a:stretch/>
            </p:blipFill>
            <p:spPr>
              <a:xfrm>
                <a:off x="577932" y="515664"/>
                <a:ext cx="3542375" cy="3329224"/>
              </a:xfrm>
              <a:prstGeom prst="rect">
                <a:avLst/>
              </a:prstGeom>
            </p:spPr>
          </p:pic>
          <p:sp>
            <p:nvSpPr>
              <p:cNvPr id="3" name="TextovéPole 2"/>
              <p:cNvSpPr txBox="1"/>
              <p:nvPr/>
            </p:nvSpPr>
            <p:spPr>
              <a:xfrm>
                <a:off x="1614668" y="290173"/>
                <a:ext cx="1349087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900" dirty="0"/>
                  <a:t>R. canina_CZ2_34</a:t>
                </a:r>
              </a:p>
            </p:txBody>
          </p:sp>
          <p:pic>
            <p:nvPicPr>
              <p:cNvPr id="5" name="Obrázek 4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26944" t="24257" r="34092" b="29287"/>
              <a:stretch/>
            </p:blipFill>
            <p:spPr>
              <a:xfrm>
                <a:off x="661011" y="3844887"/>
                <a:ext cx="2897438" cy="2994000"/>
              </a:xfrm>
              <a:prstGeom prst="rect">
                <a:avLst/>
              </a:prstGeom>
            </p:spPr>
          </p:pic>
          <p:cxnSp>
            <p:nvCxnSpPr>
              <p:cNvPr id="15" name="Přímá spojnice se šipkou 14"/>
              <p:cNvCxnSpPr/>
              <p:nvPr/>
            </p:nvCxnSpPr>
            <p:spPr>
              <a:xfrm>
                <a:off x="1235946" y="5225143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Přímá spojnice se šipkou 16"/>
              <p:cNvCxnSpPr/>
              <p:nvPr/>
            </p:nvCxnSpPr>
            <p:spPr>
              <a:xfrm>
                <a:off x="1418490" y="5779473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Přímá spojnice se šipkou 17"/>
              <p:cNvCxnSpPr/>
              <p:nvPr/>
            </p:nvCxnSpPr>
            <p:spPr>
              <a:xfrm>
                <a:off x="1631178" y="5560084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Přímá spojnice se šipkou 18"/>
              <p:cNvCxnSpPr/>
              <p:nvPr/>
            </p:nvCxnSpPr>
            <p:spPr>
              <a:xfrm>
                <a:off x="1783578" y="5571808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Přímá spojnice se šipkou 19"/>
              <p:cNvCxnSpPr/>
              <p:nvPr/>
            </p:nvCxnSpPr>
            <p:spPr>
              <a:xfrm>
                <a:off x="1895786" y="6095993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Přímá spojnice se šipkou 20"/>
              <p:cNvCxnSpPr/>
              <p:nvPr/>
            </p:nvCxnSpPr>
            <p:spPr>
              <a:xfrm>
                <a:off x="2882195" y="5102885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Přímá spojnice se šipkou 21"/>
              <p:cNvCxnSpPr/>
              <p:nvPr/>
            </p:nvCxnSpPr>
            <p:spPr>
              <a:xfrm flipH="1" flipV="1">
                <a:off x="2103502" y="6036262"/>
                <a:ext cx="6650" cy="13342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Přímá spojnice se šipkou 66"/>
              <p:cNvCxnSpPr/>
              <p:nvPr/>
            </p:nvCxnSpPr>
            <p:spPr>
              <a:xfrm>
                <a:off x="3030794" y="1843548"/>
                <a:ext cx="7374" cy="10323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Přímá spojnice se šipkou 67"/>
              <p:cNvCxnSpPr/>
              <p:nvPr/>
            </p:nvCxnSpPr>
            <p:spPr>
              <a:xfrm>
                <a:off x="1406016" y="1981194"/>
                <a:ext cx="7374" cy="10323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Přímá spojnice se šipkou 68"/>
              <p:cNvCxnSpPr/>
              <p:nvPr/>
            </p:nvCxnSpPr>
            <p:spPr>
              <a:xfrm>
                <a:off x="1823888" y="2244206"/>
                <a:ext cx="7374" cy="10323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Přímá spojnice se šipkou 69"/>
              <p:cNvCxnSpPr/>
              <p:nvPr/>
            </p:nvCxnSpPr>
            <p:spPr>
              <a:xfrm>
                <a:off x="1954166" y="2263874"/>
                <a:ext cx="7374" cy="10323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Přímá spojnice se šipkou 70"/>
              <p:cNvCxnSpPr/>
              <p:nvPr/>
            </p:nvCxnSpPr>
            <p:spPr>
              <a:xfrm>
                <a:off x="1605125" y="2490014"/>
                <a:ext cx="7374" cy="10323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Přímá spojnice se šipkou 71"/>
              <p:cNvCxnSpPr/>
              <p:nvPr/>
            </p:nvCxnSpPr>
            <p:spPr>
              <a:xfrm>
                <a:off x="2074617" y="2819392"/>
                <a:ext cx="7374" cy="10323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Přímá spojnice se šipkou 73"/>
              <p:cNvCxnSpPr/>
              <p:nvPr/>
            </p:nvCxnSpPr>
            <p:spPr>
              <a:xfrm flipH="1" flipV="1">
                <a:off x="2286000" y="2765320"/>
                <a:ext cx="7374" cy="132735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4" name="Skupina 83"/>
            <p:cNvGrpSpPr/>
            <p:nvPr/>
          </p:nvGrpSpPr>
          <p:grpSpPr>
            <a:xfrm>
              <a:off x="3445142" y="1096514"/>
              <a:ext cx="2574218" cy="4922952"/>
              <a:chOff x="4256644" y="319019"/>
              <a:chExt cx="3432290" cy="6563936"/>
            </a:xfrm>
          </p:grpSpPr>
          <p:pic>
            <p:nvPicPr>
              <p:cNvPr id="7" name="Obrázek 6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BEBA8EAE-BF5A-486C-A8C5-ECC9F3942E4B}">
                    <a14:imgProps xmlns:a14="http://schemas.microsoft.com/office/drawing/2010/main" xmlns="">
                      <a14:imgLayer r:embed="rId6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9019" t="3212" r="27073" b="25943"/>
              <a:stretch/>
            </p:blipFill>
            <p:spPr>
              <a:xfrm>
                <a:off x="4256644" y="547196"/>
                <a:ext cx="3432290" cy="3297691"/>
              </a:xfrm>
              <a:prstGeom prst="rect">
                <a:avLst/>
              </a:prstGeom>
            </p:spPr>
          </p:pic>
          <p:sp>
            <p:nvSpPr>
              <p:cNvPr id="8" name="TextovéPole 7"/>
              <p:cNvSpPr txBox="1"/>
              <p:nvPr/>
            </p:nvSpPr>
            <p:spPr>
              <a:xfrm>
                <a:off x="5419137" y="319019"/>
                <a:ext cx="1349086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900" dirty="0"/>
                  <a:t>R. canina_CZ2_36</a:t>
                </a:r>
              </a:p>
            </p:txBody>
          </p:sp>
          <p:pic>
            <p:nvPicPr>
              <p:cNvPr id="9" name="Obrázek 8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3615" t="5141" r="34730" b="31404"/>
              <a:stretch/>
            </p:blipFill>
            <p:spPr>
              <a:xfrm>
                <a:off x="4406748" y="3845002"/>
                <a:ext cx="2853369" cy="3037953"/>
              </a:xfrm>
              <a:prstGeom prst="rect">
                <a:avLst/>
              </a:prstGeom>
            </p:spPr>
          </p:pic>
          <p:cxnSp>
            <p:nvCxnSpPr>
              <p:cNvPr id="24" name="Přímá spojnice se šipkou 23"/>
              <p:cNvCxnSpPr/>
              <p:nvPr/>
            </p:nvCxnSpPr>
            <p:spPr>
              <a:xfrm>
                <a:off x="6209873" y="4732774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Přímá spojnice se šipkou 24"/>
              <p:cNvCxnSpPr/>
              <p:nvPr/>
            </p:nvCxnSpPr>
            <p:spPr>
              <a:xfrm>
                <a:off x="6020633" y="4694256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Přímá spojnice se šipkou 25"/>
              <p:cNvCxnSpPr/>
              <p:nvPr/>
            </p:nvCxnSpPr>
            <p:spPr>
              <a:xfrm>
                <a:off x="6454386" y="4354289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Přímá spojnice se šipkou 26"/>
              <p:cNvCxnSpPr/>
              <p:nvPr/>
            </p:nvCxnSpPr>
            <p:spPr>
              <a:xfrm>
                <a:off x="6255099" y="5551709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Přímá spojnice se šipkou 27"/>
              <p:cNvCxnSpPr/>
              <p:nvPr/>
            </p:nvCxnSpPr>
            <p:spPr>
              <a:xfrm>
                <a:off x="5694068" y="5523237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Přímá spojnice se šipkou 28"/>
              <p:cNvCxnSpPr/>
              <p:nvPr/>
            </p:nvCxnSpPr>
            <p:spPr>
              <a:xfrm>
                <a:off x="5967047" y="5846458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Přímá spojnice se šipkou 29"/>
              <p:cNvCxnSpPr/>
              <p:nvPr/>
            </p:nvCxnSpPr>
            <p:spPr>
              <a:xfrm>
                <a:off x="4893552" y="6280207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Přímá spojnice se šipkou 76"/>
              <p:cNvCxnSpPr/>
              <p:nvPr/>
            </p:nvCxnSpPr>
            <p:spPr>
              <a:xfrm>
                <a:off x="6515100" y="1129553"/>
                <a:ext cx="6724" cy="12774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Přímá spojnice se šipkou 77"/>
              <p:cNvCxnSpPr/>
              <p:nvPr/>
            </p:nvCxnSpPr>
            <p:spPr>
              <a:xfrm>
                <a:off x="6089273" y="1503837"/>
                <a:ext cx="6724" cy="12774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Přímá spojnice se šipkou 78"/>
              <p:cNvCxnSpPr/>
              <p:nvPr/>
            </p:nvCxnSpPr>
            <p:spPr>
              <a:xfrm>
                <a:off x="6261845" y="1481425"/>
                <a:ext cx="6724" cy="12774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Přímá spojnice se šipkou 79"/>
              <p:cNvCxnSpPr/>
              <p:nvPr/>
            </p:nvCxnSpPr>
            <p:spPr>
              <a:xfrm>
                <a:off x="6313390" y="2279293"/>
                <a:ext cx="6724" cy="12774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Přímá spojnice se šipkou 80"/>
              <p:cNvCxnSpPr/>
              <p:nvPr/>
            </p:nvCxnSpPr>
            <p:spPr>
              <a:xfrm>
                <a:off x="5726190" y="2250157"/>
                <a:ext cx="6724" cy="12774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Přímá spojnice se šipkou 81"/>
              <p:cNvCxnSpPr/>
              <p:nvPr/>
            </p:nvCxnSpPr>
            <p:spPr>
              <a:xfrm>
                <a:off x="6039961" y="2570653"/>
                <a:ext cx="6724" cy="12774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Přímá spojnice se šipkou 82"/>
              <p:cNvCxnSpPr/>
              <p:nvPr/>
            </p:nvCxnSpPr>
            <p:spPr>
              <a:xfrm>
                <a:off x="4982117" y="2971827"/>
                <a:ext cx="6724" cy="12774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3" name="Skupina 92"/>
            <p:cNvGrpSpPr/>
            <p:nvPr/>
          </p:nvGrpSpPr>
          <p:grpSpPr>
            <a:xfrm>
              <a:off x="6329174" y="1072865"/>
              <a:ext cx="2460333" cy="4913550"/>
              <a:chOff x="7825272" y="287487"/>
              <a:chExt cx="3280444" cy="6551400"/>
            </a:xfrm>
          </p:grpSpPr>
          <p:pic>
            <p:nvPicPr>
              <p:cNvPr id="12" name="Obrázek 11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BEBA8EAE-BF5A-486C-A8C5-ECC9F3942E4B}">
                    <a14:imgProps xmlns:a14="http://schemas.microsoft.com/office/drawing/2010/main" xmlns="">
                      <a14:imgLayer r:embed="rId9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24302" t="23429" r="31290" b="24570"/>
              <a:stretch/>
            </p:blipFill>
            <p:spPr>
              <a:xfrm>
                <a:off x="7825272" y="515664"/>
                <a:ext cx="3280444" cy="3329223"/>
              </a:xfrm>
              <a:prstGeom prst="rect">
                <a:avLst/>
              </a:prstGeom>
            </p:spPr>
          </p:pic>
          <p:pic>
            <p:nvPicPr>
              <p:cNvPr id="13" name="Obrázek 12"/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25127" t="27429" r="31289" b="24953"/>
              <a:stretch/>
            </p:blipFill>
            <p:spPr>
              <a:xfrm>
                <a:off x="7955605" y="3855828"/>
                <a:ext cx="3150111" cy="2983059"/>
              </a:xfrm>
              <a:prstGeom prst="rect">
                <a:avLst/>
              </a:prstGeom>
            </p:spPr>
          </p:pic>
          <p:sp>
            <p:nvSpPr>
              <p:cNvPr id="14" name="TextovéPole 13"/>
              <p:cNvSpPr txBox="1"/>
              <p:nvPr/>
            </p:nvSpPr>
            <p:spPr>
              <a:xfrm>
                <a:off x="8836536" y="287487"/>
                <a:ext cx="1349087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900" dirty="0"/>
                  <a:t>R. canina_CZ2_51</a:t>
                </a:r>
              </a:p>
            </p:txBody>
          </p:sp>
          <p:cxnSp>
            <p:nvCxnSpPr>
              <p:cNvPr id="31" name="Přímá spojnice se šipkou 30"/>
              <p:cNvCxnSpPr/>
              <p:nvPr/>
            </p:nvCxnSpPr>
            <p:spPr>
              <a:xfrm>
                <a:off x="8616455" y="5441189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Přímá spojnice se šipkou 31"/>
              <p:cNvCxnSpPr/>
              <p:nvPr/>
            </p:nvCxnSpPr>
            <p:spPr>
              <a:xfrm>
                <a:off x="10125381" y="5201711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Přímá spojnice se šipkou 32"/>
              <p:cNvCxnSpPr/>
              <p:nvPr/>
            </p:nvCxnSpPr>
            <p:spPr>
              <a:xfrm>
                <a:off x="10508891" y="4670826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Přímá spojnice se šipkou 33"/>
              <p:cNvCxnSpPr/>
              <p:nvPr/>
            </p:nvCxnSpPr>
            <p:spPr>
              <a:xfrm>
                <a:off x="10299553" y="4340909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Přímá spojnice se šipkou 34"/>
              <p:cNvCxnSpPr/>
              <p:nvPr/>
            </p:nvCxnSpPr>
            <p:spPr>
              <a:xfrm>
                <a:off x="10090216" y="6101046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Přímá spojnice se šipkou 35"/>
              <p:cNvCxnSpPr/>
              <p:nvPr/>
            </p:nvCxnSpPr>
            <p:spPr>
              <a:xfrm>
                <a:off x="9669866" y="6273540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Přímá spojnice se šipkou 36"/>
              <p:cNvCxnSpPr/>
              <p:nvPr/>
            </p:nvCxnSpPr>
            <p:spPr>
              <a:xfrm>
                <a:off x="8959770" y="4890202"/>
                <a:ext cx="5076" cy="1194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Přímá spojnice se šipkou 85"/>
              <p:cNvCxnSpPr/>
              <p:nvPr/>
            </p:nvCxnSpPr>
            <p:spPr>
              <a:xfrm>
                <a:off x="10191137" y="1144301"/>
                <a:ext cx="0" cy="12774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Přímá spojnice se šipkou 86"/>
              <p:cNvCxnSpPr/>
              <p:nvPr/>
            </p:nvCxnSpPr>
            <p:spPr>
              <a:xfrm>
                <a:off x="10395155" y="1458931"/>
                <a:ext cx="0" cy="12774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Přímá spojnice se šipkou 87"/>
              <p:cNvCxnSpPr/>
              <p:nvPr/>
            </p:nvCxnSpPr>
            <p:spPr>
              <a:xfrm>
                <a:off x="8836740" y="1729317"/>
                <a:ext cx="0" cy="12774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Přímá spojnice se šipkou 88"/>
              <p:cNvCxnSpPr/>
              <p:nvPr/>
            </p:nvCxnSpPr>
            <p:spPr>
              <a:xfrm>
                <a:off x="8487698" y="2265173"/>
                <a:ext cx="0" cy="12774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Přímá spojnice se šipkou 89"/>
              <p:cNvCxnSpPr/>
              <p:nvPr/>
            </p:nvCxnSpPr>
            <p:spPr>
              <a:xfrm>
                <a:off x="10011701" y="2041489"/>
                <a:ext cx="0" cy="12774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Přímá spojnice se šipkou 90"/>
              <p:cNvCxnSpPr/>
              <p:nvPr/>
            </p:nvCxnSpPr>
            <p:spPr>
              <a:xfrm>
                <a:off x="9994495" y="2931308"/>
                <a:ext cx="0" cy="12774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Přímá spojnice se šipkou 91"/>
              <p:cNvCxnSpPr/>
              <p:nvPr/>
            </p:nvCxnSpPr>
            <p:spPr>
              <a:xfrm>
                <a:off x="9579085" y="3113204"/>
                <a:ext cx="0" cy="127747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8" name="Zástupný symbol pro číslo snímku 5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F5404-1A97-4946-AED3-F51574ED3915}" type="slidenum">
              <a:rPr lang="cs-CZ" smtClean="0"/>
              <a:pPr/>
              <a:t>2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28504464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ovéPole 3"/>
          <p:cNvSpPr txBox="1"/>
          <p:nvPr/>
        </p:nvSpPr>
        <p:spPr>
          <a:xfrm>
            <a:off x="179512" y="553263"/>
            <a:ext cx="1665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  <a:r>
              <a:rPr lang="cs-CZ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cs-CZ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cs-CZ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nina</a:t>
            </a:r>
            <a:r>
              <a:rPr lang="cs-CZ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Z </a:t>
            </a:r>
            <a:r>
              <a:rPr lang="cs-CZ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3</a:t>
            </a:r>
            <a:endParaRPr lang="cs-CZ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" name="Skupina 11"/>
          <p:cNvGrpSpPr/>
          <p:nvPr/>
        </p:nvGrpSpPr>
        <p:grpSpPr>
          <a:xfrm>
            <a:off x="251520" y="1018015"/>
            <a:ext cx="8640960" cy="5435321"/>
            <a:chOff x="479655" y="1018015"/>
            <a:chExt cx="8242752" cy="4982735"/>
          </a:xfrm>
        </p:grpSpPr>
        <p:pic>
          <p:nvPicPr>
            <p:cNvPr id="2" name="Obrázek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 xmlns="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2516" t="9914" r="19776" b="12649"/>
            <a:stretch/>
          </p:blipFill>
          <p:spPr>
            <a:xfrm>
              <a:off x="479655" y="1203243"/>
              <a:ext cx="2487292" cy="2465522"/>
            </a:xfrm>
            <a:prstGeom prst="rect">
              <a:avLst/>
            </a:prstGeom>
          </p:spPr>
        </p:pic>
        <p:pic>
          <p:nvPicPr>
            <p:cNvPr id="3" name="Obrázek 2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3482" t="11282" r="20587" b="15726"/>
            <a:stretch/>
          </p:blipFill>
          <p:spPr>
            <a:xfrm>
              <a:off x="479655" y="3512527"/>
              <a:ext cx="2487292" cy="2386682"/>
            </a:xfrm>
            <a:prstGeom prst="rect">
              <a:avLst/>
            </a:prstGeom>
          </p:spPr>
        </p:pic>
        <p:pic>
          <p:nvPicPr>
            <p:cNvPr id="5" name="Obrázek 4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 xmlns="">
                    <a14:imgLayer r:embed="rId6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5627" t="16923" r="21850" b="13334"/>
            <a:stretch/>
          </p:blipFill>
          <p:spPr>
            <a:xfrm>
              <a:off x="3411416" y="1191856"/>
              <a:ext cx="2400300" cy="2320670"/>
            </a:xfrm>
            <a:prstGeom prst="rect">
              <a:avLst/>
            </a:prstGeom>
          </p:spPr>
        </p:pic>
        <p:pic>
          <p:nvPicPr>
            <p:cNvPr id="6" name="Obrázek 5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590" t="18290" r="27480" b="16753"/>
            <a:stretch/>
          </p:blipFill>
          <p:spPr>
            <a:xfrm>
              <a:off x="3411417" y="3512526"/>
              <a:ext cx="2379314" cy="2312378"/>
            </a:xfrm>
            <a:prstGeom prst="rect">
              <a:avLst/>
            </a:prstGeom>
          </p:spPr>
        </p:pic>
        <p:sp>
          <p:nvSpPr>
            <p:cNvPr id="7" name="TextovéPole 6"/>
            <p:cNvSpPr txBox="1"/>
            <p:nvPr/>
          </p:nvSpPr>
          <p:spPr>
            <a:xfrm>
              <a:off x="4144114" y="1028069"/>
              <a:ext cx="10118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900" dirty="0"/>
                <a:t>R. canina_CZ3_41</a:t>
              </a:r>
            </a:p>
          </p:txBody>
        </p:sp>
        <p:sp>
          <p:nvSpPr>
            <p:cNvPr id="11" name="TextovéPole 10"/>
            <p:cNvSpPr txBox="1"/>
            <p:nvPr/>
          </p:nvSpPr>
          <p:spPr>
            <a:xfrm>
              <a:off x="1178401" y="1034139"/>
              <a:ext cx="10118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900" dirty="0"/>
                <a:t>R. canina_CZ3_46</a:t>
              </a:r>
            </a:p>
          </p:txBody>
        </p:sp>
        <p:cxnSp>
          <p:nvCxnSpPr>
            <p:cNvPr id="13" name="Přímá spojnice se šipkou 12"/>
            <p:cNvCxnSpPr/>
            <p:nvPr/>
          </p:nvCxnSpPr>
          <p:spPr>
            <a:xfrm>
              <a:off x="1085738" y="4142815"/>
              <a:ext cx="4482" cy="8964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Přímá spojnice se šipkou 13"/>
            <p:cNvCxnSpPr/>
            <p:nvPr/>
          </p:nvCxnSpPr>
          <p:spPr>
            <a:xfrm>
              <a:off x="2011343" y="4001621"/>
              <a:ext cx="4482" cy="8964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Přímá spojnice se šipkou 14"/>
            <p:cNvCxnSpPr/>
            <p:nvPr/>
          </p:nvCxnSpPr>
          <p:spPr>
            <a:xfrm>
              <a:off x="2233220" y="4277286"/>
              <a:ext cx="4482" cy="8964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Přímá spojnice se šipkou 15"/>
            <p:cNvCxnSpPr/>
            <p:nvPr/>
          </p:nvCxnSpPr>
          <p:spPr>
            <a:xfrm>
              <a:off x="1723300" y="4517091"/>
              <a:ext cx="4482" cy="8964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Přímá spojnice se šipkou 16"/>
            <p:cNvCxnSpPr/>
            <p:nvPr/>
          </p:nvCxnSpPr>
          <p:spPr>
            <a:xfrm>
              <a:off x="1313165" y="4322109"/>
              <a:ext cx="4482" cy="8964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Přímá spojnice se šipkou 17"/>
            <p:cNvCxnSpPr/>
            <p:nvPr/>
          </p:nvCxnSpPr>
          <p:spPr>
            <a:xfrm>
              <a:off x="1178400" y="4668715"/>
              <a:ext cx="4482" cy="8964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Přímá spojnice se šipkou 18"/>
            <p:cNvCxnSpPr/>
            <p:nvPr/>
          </p:nvCxnSpPr>
          <p:spPr>
            <a:xfrm>
              <a:off x="1566124" y="5356756"/>
              <a:ext cx="4482" cy="8964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Přímá spojnice se šipkou 20"/>
            <p:cNvCxnSpPr/>
            <p:nvPr/>
          </p:nvCxnSpPr>
          <p:spPr>
            <a:xfrm>
              <a:off x="3980330" y="3860967"/>
              <a:ext cx="0" cy="8964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Přímá spojnice se šipkou 21"/>
            <p:cNvCxnSpPr/>
            <p:nvPr/>
          </p:nvCxnSpPr>
          <p:spPr>
            <a:xfrm>
              <a:off x="4493559" y="3668765"/>
              <a:ext cx="0" cy="8964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Přímá spojnice se šipkou 22"/>
            <p:cNvCxnSpPr/>
            <p:nvPr/>
          </p:nvCxnSpPr>
          <p:spPr>
            <a:xfrm>
              <a:off x="4638115" y="3668764"/>
              <a:ext cx="0" cy="8964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Přímá spojnice se šipkou 23"/>
            <p:cNvCxnSpPr/>
            <p:nvPr/>
          </p:nvCxnSpPr>
          <p:spPr>
            <a:xfrm>
              <a:off x="4752415" y="4427445"/>
              <a:ext cx="0" cy="8964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Přímá spojnice se šipkou 24"/>
            <p:cNvCxnSpPr/>
            <p:nvPr/>
          </p:nvCxnSpPr>
          <p:spPr>
            <a:xfrm>
              <a:off x="4221256" y="4557432"/>
              <a:ext cx="0" cy="8964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Přímá spojnice se šipkou 25"/>
            <p:cNvCxnSpPr/>
            <p:nvPr/>
          </p:nvCxnSpPr>
          <p:spPr>
            <a:xfrm>
              <a:off x="4175488" y="4904814"/>
              <a:ext cx="0" cy="8964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Přímá spojnice se šipkou 26"/>
            <p:cNvCxnSpPr/>
            <p:nvPr/>
          </p:nvCxnSpPr>
          <p:spPr>
            <a:xfrm>
              <a:off x="4679576" y="4949637"/>
              <a:ext cx="68532" cy="8740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Přímá spojnice se šipkou 38"/>
            <p:cNvCxnSpPr/>
            <p:nvPr/>
          </p:nvCxnSpPr>
          <p:spPr>
            <a:xfrm>
              <a:off x="2011343" y="1692434"/>
              <a:ext cx="0" cy="108642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Přímá spojnice se šipkou 39"/>
            <p:cNvCxnSpPr/>
            <p:nvPr/>
          </p:nvCxnSpPr>
          <p:spPr>
            <a:xfrm>
              <a:off x="2213913" y="1949322"/>
              <a:ext cx="0" cy="108642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Přímá spojnice se šipkou 40"/>
            <p:cNvCxnSpPr/>
            <p:nvPr/>
          </p:nvCxnSpPr>
          <p:spPr>
            <a:xfrm>
              <a:off x="1133165" y="1812391"/>
              <a:ext cx="0" cy="108642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Přímá spojnice se šipkou 41"/>
            <p:cNvCxnSpPr/>
            <p:nvPr/>
          </p:nvCxnSpPr>
          <p:spPr>
            <a:xfrm>
              <a:off x="1328945" y="2014958"/>
              <a:ext cx="0" cy="108642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Přímá spojnice se šipkou 42"/>
            <p:cNvCxnSpPr/>
            <p:nvPr/>
          </p:nvCxnSpPr>
          <p:spPr>
            <a:xfrm>
              <a:off x="1714846" y="2197157"/>
              <a:ext cx="0" cy="108642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Přímá spojnice se šipkou 43"/>
            <p:cNvCxnSpPr/>
            <p:nvPr/>
          </p:nvCxnSpPr>
          <p:spPr>
            <a:xfrm>
              <a:off x="1184089" y="2311457"/>
              <a:ext cx="0" cy="108642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Přímá spojnice se šipkou 44"/>
            <p:cNvCxnSpPr/>
            <p:nvPr/>
          </p:nvCxnSpPr>
          <p:spPr>
            <a:xfrm>
              <a:off x="1569989" y="3009699"/>
              <a:ext cx="0" cy="108642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Přímá spojnice se šipkou 46"/>
            <p:cNvCxnSpPr/>
            <p:nvPr/>
          </p:nvCxnSpPr>
          <p:spPr>
            <a:xfrm>
              <a:off x="4379614" y="1359718"/>
              <a:ext cx="6791" cy="122222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Přímá spojnice se šipkou 47"/>
            <p:cNvCxnSpPr/>
            <p:nvPr/>
          </p:nvCxnSpPr>
          <p:spPr>
            <a:xfrm>
              <a:off x="4514283" y="1365379"/>
              <a:ext cx="6791" cy="122222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Přímá spojnice se šipkou 48"/>
            <p:cNvCxnSpPr/>
            <p:nvPr/>
          </p:nvCxnSpPr>
          <p:spPr>
            <a:xfrm>
              <a:off x="3915628" y="1547577"/>
              <a:ext cx="6791" cy="122222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Přímá spojnice se šipkou 49"/>
            <p:cNvCxnSpPr/>
            <p:nvPr/>
          </p:nvCxnSpPr>
          <p:spPr>
            <a:xfrm>
              <a:off x="4118195" y="2143971"/>
              <a:ext cx="6791" cy="122222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Přímá spojnice se šipkou 50"/>
            <p:cNvCxnSpPr/>
            <p:nvPr/>
          </p:nvCxnSpPr>
          <p:spPr>
            <a:xfrm>
              <a:off x="4619526" y="2047781"/>
              <a:ext cx="6791" cy="122222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Přímá spojnice se šipkou 51"/>
            <p:cNvCxnSpPr/>
            <p:nvPr/>
          </p:nvCxnSpPr>
          <p:spPr>
            <a:xfrm>
              <a:off x="4075193" y="2501587"/>
              <a:ext cx="6791" cy="122222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Přímá spojnice se šipkou 52"/>
            <p:cNvCxnSpPr/>
            <p:nvPr/>
          </p:nvCxnSpPr>
          <p:spPr>
            <a:xfrm>
              <a:off x="4569736" y="2568355"/>
              <a:ext cx="88271" cy="8148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8" name="Skupina 67"/>
            <p:cNvGrpSpPr/>
            <p:nvPr/>
          </p:nvGrpSpPr>
          <p:grpSpPr>
            <a:xfrm>
              <a:off x="6279249" y="1018015"/>
              <a:ext cx="2443158" cy="4982735"/>
              <a:chOff x="8552812" y="214353"/>
              <a:chExt cx="3257544" cy="6643647"/>
            </a:xfrm>
          </p:grpSpPr>
          <p:pic>
            <p:nvPicPr>
              <p:cNvPr id="8" name="Obrázek 7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0441" t="13845" r="18738" b="5470"/>
              <a:stretch/>
            </p:blipFill>
            <p:spPr>
              <a:xfrm>
                <a:off x="8593016" y="3681045"/>
                <a:ext cx="3217340" cy="3176955"/>
              </a:xfrm>
              <a:prstGeom prst="rect">
                <a:avLst/>
              </a:prstGeom>
            </p:spPr>
          </p:pic>
          <p:sp>
            <p:nvSpPr>
              <p:cNvPr id="9" name="TextovéPole 8"/>
              <p:cNvSpPr txBox="1"/>
              <p:nvPr/>
            </p:nvSpPr>
            <p:spPr>
              <a:xfrm>
                <a:off x="9458827" y="214353"/>
                <a:ext cx="1349087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900" dirty="0"/>
                  <a:t>R. canina_CZ3_32</a:t>
                </a:r>
              </a:p>
            </p:txBody>
          </p:sp>
          <p:pic>
            <p:nvPicPr>
              <p:cNvPr id="10" name="Obrázek 9"/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BEBA8EAE-BF5A-486C-A8C5-ECC9F3942E4B}">
                    <a14:imgProps xmlns:a14="http://schemas.microsoft.com/office/drawing/2010/main" xmlns="">
                      <a14:imgLayer r:embed="rId10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8071" t="11625" r="13405" b="3932"/>
              <a:stretch/>
            </p:blipFill>
            <p:spPr>
              <a:xfrm>
                <a:off x="8552812" y="446143"/>
                <a:ext cx="3257544" cy="3094226"/>
              </a:xfrm>
              <a:prstGeom prst="rect">
                <a:avLst/>
              </a:prstGeom>
            </p:spPr>
          </p:pic>
          <p:cxnSp>
            <p:nvCxnSpPr>
              <p:cNvPr id="30" name="Přímá spojnice se šipkou 29"/>
              <p:cNvCxnSpPr/>
              <p:nvPr/>
            </p:nvCxnSpPr>
            <p:spPr>
              <a:xfrm>
                <a:off x="9078259" y="4312023"/>
                <a:ext cx="89647" cy="9861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Přímá spojnice se šipkou 30"/>
              <p:cNvCxnSpPr/>
              <p:nvPr/>
            </p:nvCxnSpPr>
            <p:spPr>
              <a:xfrm>
                <a:off x="8854142" y="4933576"/>
                <a:ext cx="89647" cy="9861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Přímá spojnice se šipkou 31"/>
              <p:cNvCxnSpPr/>
              <p:nvPr/>
            </p:nvCxnSpPr>
            <p:spPr>
              <a:xfrm>
                <a:off x="8794378" y="5032188"/>
                <a:ext cx="89647" cy="9861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Přímá spojnice se šipkou 33"/>
              <p:cNvCxnSpPr/>
              <p:nvPr/>
            </p:nvCxnSpPr>
            <p:spPr>
              <a:xfrm>
                <a:off x="10487902" y="3969100"/>
                <a:ext cx="0" cy="12777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Přímá spojnice se šipkou 34"/>
              <p:cNvCxnSpPr/>
              <p:nvPr/>
            </p:nvCxnSpPr>
            <p:spPr>
              <a:xfrm>
                <a:off x="10897290" y="4855107"/>
                <a:ext cx="0" cy="12777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Přímá spojnice se šipkou 35"/>
              <p:cNvCxnSpPr/>
              <p:nvPr/>
            </p:nvCxnSpPr>
            <p:spPr>
              <a:xfrm>
                <a:off x="11306678" y="5066912"/>
                <a:ext cx="0" cy="12777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Přímá spojnice se šipkou 36"/>
              <p:cNvCxnSpPr/>
              <p:nvPr/>
            </p:nvCxnSpPr>
            <p:spPr>
              <a:xfrm>
                <a:off x="9994842" y="5083805"/>
                <a:ext cx="0" cy="12777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Přímá spojnice se šipkou 57"/>
              <p:cNvCxnSpPr/>
              <p:nvPr/>
            </p:nvCxnSpPr>
            <p:spPr>
              <a:xfrm flipH="1">
                <a:off x="10411485" y="740876"/>
                <a:ext cx="9054" cy="16296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Přímá spojnice se šipkou 60"/>
              <p:cNvCxnSpPr/>
              <p:nvPr/>
            </p:nvCxnSpPr>
            <p:spPr>
              <a:xfrm flipH="1">
                <a:off x="9957305" y="1780506"/>
                <a:ext cx="9054" cy="16296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Přímá spojnice se šipkou 61"/>
              <p:cNvCxnSpPr/>
              <p:nvPr/>
            </p:nvCxnSpPr>
            <p:spPr>
              <a:xfrm flipH="1">
                <a:off x="10761553" y="1570772"/>
                <a:ext cx="9054" cy="16296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Přímá spojnice se šipkou 62"/>
              <p:cNvCxnSpPr/>
              <p:nvPr/>
            </p:nvCxnSpPr>
            <p:spPr>
              <a:xfrm flipH="1">
                <a:off x="11176498" y="1750331"/>
                <a:ext cx="9054" cy="16296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Přímá spojnice se šipkou 63"/>
              <p:cNvCxnSpPr/>
              <p:nvPr/>
            </p:nvCxnSpPr>
            <p:spPr>
              <a:xfrm>
                <a:off x="9079585" y="1131682"/>
                <a:ext cx="97610" cy="6789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Přímá spojnice se šipkou 65"/>
              <p:cNvCxnSpPr/>
              <p:nvPr/>
            </p:nvCxnSpPr>
            <p:spPr>
              <a:xfrm>
                <a:off x="8860794" y="1700535"/>
                <a:ext cx="97610" cy="6789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Přímá spojnice se šipkou 66"/>
              <p:cNvCxnSpPr/>
              <p:nvPr/>
            </p:nvCxnSpPr>
            <p:spPr>
              <a:xfrm>
                <a:off x="8832130" y="1780511"/>
                <a:ext cx="97610" cy="6789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6" name="Zástupný symbol pro číslo snímku 5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F5404-1A97-4946-AED3-F51574ED3915}" type="slidenum">
              <a:rPr lang="cs-CZ" smtClean="0"/>
              <a:pPr/>
              <a:t>3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27405187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ovéPole 3"/>
          <p:cNvSpPr txBox="1"/>
          <p:nvPr/>
        </p:nvSpPr>
        <p:spPr>
          <a:xfrm>
            <a:off x="243628" y="655127"/>
            <a:ext cx="1069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cs-CZ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cs-CZ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cs-CZ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odora</a:t>
            </a:r>
            <a:endParaRPr lang="cs-CZ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Skupina 2"/>
          <p:cNvGrpSpPr/>
          <p:nvPr/>
        </p:nvGrpSpPr>
        <p:grpSpPr>
          <a:xfrm>
            <a:off x="323528" y="1034154"/>
            <a:ext cx="8568952" cy="5131150"/>
            <a:chOff x="650302" y="1263559"/>
            <a:chExt cx="7936270" cy="4715742"/>
          </a:xfrm>
        </p:grpSpPr>
        <p:grpSp>
          <p:nvGrpSpPr>
            <p:cNvPr id="26" name="Skupina 25"/>
            <p:cNvGrpSpPr/>
            <p:nvPr/>
          </p:nvGrpSpPr>
          <p:grpSpPr>
            <a:xfrm>
              <a:off x="6220368" y="1297471"/>
              <a:ext cx="2366204" cy="4681830"/>
              <a:chOff x="8293824" y="586961"/>
              <a:chExt cx="3154938" cy="6242440"/>
            </a:xfrm>
          </p:grpSpPr>
          <p:grpSp>
            <p:nvGrpSpPr>
              <p:cNvPr id="16" name="Skupina 15"/>
              <p:cNvGrpSpPr/>
              <p:nvPr/>
            </p:nvGrpSpPr>
            <p:grpSpPr>
              <a:xfrm>
                <a:off x="8293824" y="586961"/>
                <a:ext cx="3102722" cy="3389795"/>
                <a:chOff x="8293824" y="575041"/>
                <a:chExt cx="2903831" cy="3014193"/>
              </a:xfrm>
            </p:grpSpPr>
            <p:sp>
              <p:nvSpPr>
                <p:cNvPr id="9" name="TextovéPole 8"/>
                <p:cNvSpPr txBox="1"/>
                <p:nvPr/>
              </p:nvSpPr>
              <p:spPr>
                <a:xfrm>
                  <a:off x="10016350" y="780208"/>
                  <a:ext cx="828537" cy="27367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cs-CZ" sz="900" i="1" dirty="0"/>
                    <a:t>inodora38</a:t>
                  </a:r>
                </a:p>
              </p:txBody>
            </p:sp>
            <p:pic>
              <p:nvPicPr>
                <p:cNvPr id="10" name="Obrázek 9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BEBA8EAE-BF5A-486C-A8C5-ECC9F3942E4B}">
                      <a14:imgProps xmlns:a14="http://schemas.microsoft.com/office/drawing/2010/main" xmlns="">
                        <a14:imgLayer r:embed="rId3">
                          <a14:imgEffect>
                            <a14:brightnessContrast bright="44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32372" t="20550" r="6313" b="12628"/>
                <a:stretch/>
              </p:blipFill>
              <p:spPr>
                <a:xfrm>
                  <a:off x="8293824" y="769075"/>
                  <a:ext cx="2903831" cy="2820159"/>
                </a:xfrm>
                <a:prstGeom prst="rect">
                  <a:avLst/>
                </a:prstGeom>
              </p:spPr>
            </p:pic>
            <p:sp>
              <p:nvSpPr>
                <p:cNvPr id="33" name="TextovéPole 32"/>
                <p:cNvSpPr txBox="1"/>
                <p:nvPr/>
              </p:nvSpPr>
              <p:spPr>
                <a:xfrm>
                  <a:off x="9433289" y="575041"/>
                  <a:ext cx="830537" cy="27367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cs-CZ" sz="900" dirty="0"/>
                    <a:t>inodora38</a:t>
                  </a:r>
                  <a:endParaRPr lang="cs-CZ" sz="900" i="1" dirty="0"/>
                </a:p>
              </p:txBody>
            </p:sp>
            <p:cxnSp>
              <p:nvCxnSpPr>
                <p:cNvPr id="85" name="Přímá spojnice se šipkou 84"/>
                <p:cNvCxnSpPr/>
                <p:nvPr/>
              </p:nvCxnSpPr>
              <p:spPr>
                <a:xfrm>
                  <a:off x="10297093" y="863822"/>
                  <a:ext cx="0" cy="109770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Přímá spojnice se šipkou 85"/>
                <p:cNvCxnSpPr/>
                <p:nvPr/>
              </p:nvCxnSpPr>
              <p:spPr>
                <a:xfrm>
                  <a:off x="9263787" y="2922651"/>
                  <a:ext cx="0" cy="109770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Přímá spojnice se šipkou 86"/>
                <p:cNvCxnSpPr/>
                <p:nvPr/>
              </p:nvCxnSpPr>
              <p:spPr>
                <a:xfrm>
                  <a:off x="8712803" y="2188947"/>
                  <a:ext cx="0" cy="109770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Přímá spojnice se šipkou 87"/>
                <p:cNvCxnSpPr/>
                <p:nvPr/>
              </p:nvCxnSpPr>
              <p:spPr>
                <a:xfrm flipH="1">
                  <a:off x="8995832" y="2575015"/>
                  <a:ext cx="72555" cy="78488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2" name="Přímá spojnice se šipkou 91"/>
                <p:cNvCxnSpPr/>
                <p:nvPr/>
              </p:nvCxnSpPr>
              <p:spPr>
                <a:xfrm flipH="1">
                  <a:off x="9697840" y="2516587"/>
                  <a:ext cx="72555" cy="78488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3" name="Přímá spojnice se šipkou 92"/>
                <p:cNvCxnSpPr/>
                <p:nvPr/>
              </p:nvCxnSpPr>
              <p:spPr>
                <a:xfrm flipH="1">
                  <a:off x="9661562" y="1905712"/>
                  <a:ext cx="72555" cy="78488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Přímá spojnice se šipkou 93"/>
                <p:cNvCxnSpPr/>
                <p:nvPr/>
              </p:nvCxnSpPr>
              <p:spPr>
                <a:xfrm flipH="1">
                  <a:off x="9582580" y="2719477"/>
                  <a:ext cx="72555" cy="78488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7" name="Skupina 16"/>
              <p:cNvGrpSpPr/>
              <p:nvPr/>
            </p:nvGrpSpPr>
            <p:grpSpPr>
              <a:xfrm>
                <a:off x="8293824" y="3897338"/>
                <a:ext cx="3154938" cy="2932063"/>
                <a:chOff x="8191814" y="3729387"/>
                <a:chExt cx="3107849" cy="3150915"/>
              </a:xfrm>
            </p:grpSpPr>
            <p:pic>
              <p:nvPicPr>
                <p:cNvPr id="76" name="Obrázek 75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30875" t="20078" r="10255" b="11059"/>
                <a:stretch/>
              </p:blipFill>
              <p:spPr>
                <a:xfrm>
                  <a:off x="8191814" y="3729387"/>
                  <a:ext cx="3107849" cy="3150915"/>
                </a:xfrm>
                <a:prstGeom prst="rect">
                  <a:avLst/>
                </a:prstGeom>
              </p:spPr>
            </p:pic>
            <p:cxnSp>
              <p:nvCxnSpPr>
                <p:cNvPr id="95" name="Přímá spojnice se šipkou 94"/>
                <p:cNvCxnSpPr/>
                <p:nvPr/>
              </p:nvCxnSpPr>
              <p:spPr>
                <a:xfrm>
                  <a:off x="10503281" y="3866986"/>
                  <a:ext cx="0" cy="10977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Přímá spojnice se šipkou 95"/>
                <p:cNvCxnSpPr/>
                <p:nvPr/>
              </p:nvCxnSpPr>
              <p:spPr>
                <a:xfrm>
                  <a:off x="9341717" y="6124802"/>
                  <a:ext cx="0" cy="10977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7" name="Přímá spojnice se šipkou 96"/>
                <p:cNvCxnSpPr/>
                <p:nvPr/>
              </p:nvCxnSpPr>
              <p:spPr>
                <a:xfrm>
                  <a:off x="8764137" y="5270598"/>
                  <a:ext cx="0" cy="10977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8" name="Přímá spojnice se šipkou 97"/>
                <p:cNvCxnSpPr/>
                <p:nvPr/>
              </p:nvCxnSpPr>
              <p:spPr>
                <a:xfrm flipH="1">
                  <a:off x="9040656" y="5731859"/>
                  <a:ext cx="72555" cy="78488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9" name="Přímá spojnice se šipkou 98"/>
                <p:cNvCxnSpPr/>
                <p:nvPr/>
              </p:nvCxnSpPr>
              <p:spPr>
                <a:xfrm flipH="1">
                  <a:off x="9661780" y="5853523"/>
                  <a:ext cx="72555" cy="78488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0" name="Přímá spojnice se šipkou 99"/>
                <p:cNvCxnSpPr/>
                <p:nvPr/>
              </p:nvCxnSpPr>
              <p:spPr>
                <a:xfrm flipH="1">
                  <a:off x="9806496" y="5598671"/>
                  <a:ext cx="72555" cy="78488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Přímá spojnice se šipkou 100"/>
                <p:cNvCxnSpPr/>
                <p:nvPr/>
              </p:nvCxnSpPr>
              <p:spPr>
                <a:xfrm flipH="1">
                  <a:off x="9782164" y="4959619"/>
                  <a:ext cx="72555" cy="78488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8" name="Skupina 27"/>
            <p:cNvGrpSpPr/>
            <p:nvPr/>
          </p:nvGrpSpPr>
          <p:grpSpPr>
            <a:xfrm>
              <a:off x="650302" y="1288061"/>
              <a:ext cx="2484782" cy="4691240"/>
              <a:chOff x="867069" y="574414"/>
              <a:chExt cx="3313043" cy="6254987"/>
            </a:xfrm>
          </p:grpSpPr>
          <p:grpSp>
            <p:nvGrpSpPr>
              <p:cNvPr id="35" name="Skupina 34"/>
              <p:cNvGrpSpPr/>
              <p:nvPr/>
            </p:nvGrpSpPr>
            <p:grpSpPr>
              <a:xfrm>
                <a:off x="867069" y="3690725"/>
                <a:ext cx="3313043" cy="3138676"/>
                <a:chOff x="487661" y="3286461"/>
                <a:chExt cx="3589486" cy="3571539"/>
              </a:xfrm>
            </p:grpSpPr>
            <p:pic>
              <p:nvPicPr>
                <p:cNvPr id="36" name="Obrázek 35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30331" t="18979" r="15285" b="18589"/>
                <a:stretch/>
              </p:blipFill>
              <p:spPr>
                <a:xfrm>
                  <a:off x="487661" y="3286461"/>
                  <a:ext cx="3589486" cy="3571539"/>
                </a:xfrm>
                <a:prstGeom prst="rect">
                  <a:avLst/>
                </a:prstGeom>
              </p:spPr>
            </p:pic>
            <p:grpSp>
              <p:nvGrpSpPr>
                <p:cNvPr id="37" name="Skupina 36"/>
                <p:cNvGrpSpPr/>
                <p:nvPr/>
              </p:nvGrpSpPr>
              <p:grpSpPr>
                <a:xfrm>
                  <a:off x="1229833" y="3960101"/>
                  <a:ext cx="1958683" cy="1819146"/>
                  <a:chOff x="1229833" y="3960101"/>
                  <a:chExt cx="1958683" cy="1819146"/>
                </a:xfrm>
              </p:grpSpPr>
              <p:cxnSp>
                <p:nvCxnSpPr>
                  <p:cNvPr id="59" name="Přímá spojnice se šipkou 58"/>
                  <p:cNvCxnSpPr/>
                  <p:nvPr/>
                </p:nvCxnSpPr>
                <p:spPr>
                  <a:xfrm flipH="1">
                    <a:off x="1229833" y="4322171"/>
                    <a:ext cx="4221" cy="98251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0" name="Přímá spojnice se šipkou 59"/>
                  <p:cNvCxnSpPr/>
                  <p:nvPr/>
                </p:nvCxnSpPr>
                <p:spPr>
                  <a:xfrm>
                    <a:off x="1889093" y="4509007"/>
                    <a:ext cx="81827" cy="81912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" name="Přímá spojnice se šipkou 60"/>
                  <p:cNvCxnSpPr/>
                  <p:nvPr/>
                </p:nvCxnSpPr>
                <p:spPr>
                  <a:xfrm>
                    <a:off x="2290032" y="3960101"/>
                    <a:ext cx="81827" cy="81912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2" name="Přímá spojnice se šipkou 61"/>
                  <p:cNvCxnSpPr/>
                  <p:nvPr/>
                </p:nvCxnSpPr>
                <p:spPr>
                  <a:xfrm>
                    <a:off x="2484013" y="5653750"/>
                    <a:ext cx="54589" cy="125497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" name="Přímá spojnice se šipkou 62"/>
                  <p:cNvCxnSpPr/>
                  <p:nvPr/>
                </p:nvCxnSpPr>
                <p:spPr>
                  <a:xfrm>
                    <a:off x="2679598" y="4577831"/>
                    <a:ext cx="115779" cy="55076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" name="Přímá spojnice se šipkou 64"/>
                  <p:cNvCxnSpPr/>
                  <p:nvPr/>
                </p:nvCxnSpPr>
                <p:spPr>
                  <a:xfrm>
                    <a:off x="3188515" y="4691263"/>
                    <a:ext cx="1" cy="119254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03" name="Skupina 102"/>
              <p:cNvGrpSpPr/>
              <p:nvPr/>
            </p:nvGrpSpPr>
            <p:grpSpPr>
              <a:xfrm>
                <a:off x="867070" y="574414"/>
                <a:ext cx="3138828" cy="3409392"/>
                <a:chOff x="802276" y="564582"/>
                <a:chExt cx="2757577" cy="2964242"/>
              </a:xfrm>
            </p:grpSpPr>
            <p:sp>
              <p:nvSpPr>
                <p:cNvPr id="5" name="TextovéPole 4"/>
                <p:cNvSpPr txBox="1"/>
                <p:nvPr/>
              </p:nvSpPr>
              <p:spPr>
                <a:xfrm>
                  <a:off x="1742165" y="564582"/>
                  <a:ext cx="779634" cy="26759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cs-CZ" sz="900" dirty="0"/>
                    <a:t>inodora90</a:t>
                  </a:r>
                </a:p>
              </p:txBody>
            </p:sp>
            <p:pic>
              <p:nvPicPr>
                <p:cNvPr id="6" name="Obrázek 5"/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BEBA8EAE-BF5A-486C-A8C5-ECC9F3942E4B}">
                      <a14:imgProps xmlns:a14="http://schemas.microsoft.com/office/drawing/2010/main" xmlns="">
                        <a14:imgLayer r:embed="rId7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24622" t="19922" r="24939" b="21568"/>
                <a:stretch/>
              </p:blipFill>
              <p:spPr>
                <a:xfrm>
                  <a:off x="802276" y="756380"/>
                  <a:ext cx="2757577" cy="2772444"/>
                </a:xfrm>
                <a:prstGeom prst="rect">
                  <a:avLst/>
                </a:prstGeom>
              </p:spPr>
            </p:pic>
            <p:cxnSp>
              <p:nvCxnSpPr>
                <p:cNvPr id="67" name="Přímá spojnice se šipkou 66"/>
                <p:cNvCxnSpPr/>
                <p:nvPr/>
              </p:nvCxnSpPr>
              <p:spPr>
                <a:xfrm>
                  <a:off x="2263629" y="1162228"/>
                  <a:ext cx="72625" cy="111095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Přímá spojnice se šipkou 67"/>
                <p:cNvCxnSpPr/>
                <p:nvPr/>
              </p:nvCxnSpPr>
              <p:spPr>
                <a:xfrm>
                  <a:off x="2581660" y="1710485"/>
                  <a:ext cx="129187" cy="22888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" name="Přímá spojnice se šipkou 69"/>
                <p:cNvCxnSpPr/>
                <p:nvPr/>
              </p:nvCxnSpPr>
              <p:spPr>
                <a:xfrm>
                  <a:off x="2588778" y="1811609"/>
                  <a:ext cx="129187" cy="22888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2" name="Přímá spojnice se šipkou 71"/>
                <p:cNvCxnSpPr/>
                <p:nvPr/>
              </p:nvCxnSpPr>
              <p:spPr>
                <a:xfrm>
                  <a:off x="3034644" y="1795942"/>
                  <a:ext cx="0" cy="109770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Přímá spojnice se šipkou 72"/>
                <p:cNvCxnSpPr/>
                <p:nvPr/>
              </p:nvCxnSpPr>
              <p:spPr>
                <a:xfrm>
                  <a:off x="1392427" y="1452686"/>
                  <a:ext cx="0" cy="109770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Přímá spojnice se šipkou 73"/>
                <p:cNvCxnSpPr/>
                <p:nvPr/>
              </p:nvCxnSpPr>
              <p:spPr>
                <a:xfrm>
                  <a:off x="1937464" y="1605186"/>
                  <a:ext cx="72625" cy="111095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Přímá spojnice se šipkou 74"/>
                <p:cNvCxnSpPr/>
                <p:nvPr/>
              </p:nvCxnSpPr>
              <p:spPr>
                <a:xfrm>
                  <a:off x="2423148" y="2595075"/>
                  <a:ext cx="72625" cy="111095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66" name="Přímá spojnice se šipkou 65"/>
              <p:cNvCxnSpPr/>
              <p:nvPr/>
            </p:nvCxnSpPr>
            <p:spPr>
              <a:xfrm>
                <a:off x="2881566" y="4931820"/>
                <a:ext cx="106862" cy="4840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Skupina 26"/>
            <p:cNvGrpSpPr/>
            <p:nvPr/>
          </p:nvGrpSpPr>
          <p:grpSpPr>
            <a:xfrm>
              <a:off x="3389273" y="1263559"/>
              <a:ext cx="2428299" cy="4683341"/>
              <a:chOff x="4519030" y="541745"/>
              <a:chExt cx="3237732" cy="6244455"/>
            </a:xfrm>
          </p:grpSpPr>
          <p:grpSp>
            <p:nvGrpSpPr>
              <p:cNvPr id="15" name="Skupina 14"/>
              <p:cNvGrpSpPr/>
              <p:nvPr/>
            </p:nvGrpSpPr>
            <p:grpSpPr>
              <a:xfrm>
                <a:off x="4519030" y="541745"/>
                <a:ext cx="3237732" cy="3435011"/>
                <a:chOff x="4084135" y="532273"/>
                <a:chExt cx="2908477" cy="3056961"/>
              </a:xfrm>
            </p:grpSpPr>
            <p:sp>
              <p:nvSpPr>
                <p:cNvPr id="8" name="TextovéPole 7"/>
                <p:cNvSpPr txBox="1"/>
                <p:nvPr/>
              </p:nvSpPr>
              <p:spPr>
                <a:xfrm>
                  <a:off x="5195831" y="532273"/>
                  <a:ext cx="797178" cy="2739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cs-CZ" sz="900" dirty="0"/>
                    <a:t>inodora37</a:t>
                  </a:r>
                </a:p>
              </p:txBody>
            </p:sp>
            <p:cxnSp>
              <p:nvCxnSpPr>
                <p:cNvPr id="18" name="Přímá spojnice se šipkou 17"/>
                <p:cNvCxnSpPr/>
                <p:nvPr/>
              </p:nvCxnSpPr>
              <p:spPr>
                <a:xfrm flipH="1">
                  <a:off x="6330659" y="1696641"/>
                  <a:ext cx="26216" cy="99301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Přímá spojnice se šipkou 18"/>
                <p:cNvCxnSpPr/>
                <p:nvPr/>
              </p:nvCxnSpPr>
              <p:spPr>
                <a:xfrm flipH="1">
                  <a:off x="6799252" y="2275932"/>
                  <a:ext cx="73819" cy="65519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Přímá spojnice se šipkou 19"/>
                <p:cNvCxnSpPr/>
                <p:nvPr/>
              </p:nvCxnSpPr>
              <p:spPr>
                <a:xfrm flipH="1">
                  <a:off x="5987400" y="3207819"/>
                  <a:ext cx="26216" cy="99301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Přímá spojnice se šipkou 20"/>
                <p:cNvCxnSpPr/>
                <p:nvPr/>
              </p:nvCxnSpPr>
              <p:spPr>
                <a:xfrm flipH="1">
                  <a:off x="6139800" y="3197847"/>
                  <a:ext cx="26216" cy="99301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Přímá spojnice se šipkou 21"/>
                <p:cNvCxnSpPr/>
                <p:nvPr/>
              </p:nvCxnSpPr>
              <p:spPr>
                <a:xfrm flipH="1">
                  <a:off x="6020159" y="2274507"/>
                  <a:ext cx="78523" cy="48420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Přímá spojnice se šipkou 22"/>
                <p:cNvCxnSpPr/>
                <p:nvPr/>
              </p:nvCxnSpPr>
              <p:spPr>
                <a:xfrm>
                  <a:off x="5104541" y="2687529"/>
                  <a:ext cx="68161" cy="18535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Přímá spojnice se šipkou 23"/>
                <p:cNvCxnSpPr/>
                <p:nvPr/>
              </p:nvCxnSpPr>
              <p:spPr>
                <a:xfrm flipH="1">
                  <a:off x="5753814" y="2691828"/>
                  <a:ext cx="78523" cy="48420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34" name="Obrázek 33"/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extLst>
                    <a:ext uri="{BEBA8EAE-BF5A-486C-A8C5-ECC9F3942E4B}">
                      <a14:imgProps xmlns:a14="http://schemas.microsoft.com/office/drawing/2010/main" xmlns="">
                        <a14:imgLayer r:embed="rId9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21766" t="25882" r="32280" b="19686"/>
                <a:stretch/>
              </p:blipFill>
              <p:spPr>
                <a:xfrm>
                  <a:off x="4084135" y="732680"/>
                  <a:ext cx="2908477" cy="2856554"/>
                </a:xfrm>
                <a:prstGeom prst="rect">
                  <a:avLst/>
                </a:prstGeom>
              </p:spPr>
            </p:pic>
            <p:cxnSp>
              <p:nvCxnSpPr>
                <p:cNvPr id="77" name="Přímá spojnice se šipkou 76"/>
                <p:cNvCxnSpPr/>
                <p:nvPr/>
              </p:nvCxnSpPr>
              <p:spPr>
                <a:xfrm>
                  <a:off x="5753814" y="918707"/>
                  <a:ext cx="0" cy="109770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Přímá spojnice se šipkou 77"/>
                <p:cNvCxnSpPr/>
                <p:nvPr/>
              </p:nvCxnSpPr>
              <p:spPr>
                <a:xfrm>
                  <a:off x="6237810" y="1741057"/>
                  <a:ext cx="0" cy="109770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9" name="Přímá spojnice se šipkou 78"/>
                <p:cNvCxnSpPr/>
                <p:nvPr/>
              </p:nvCxnSpPr>
              <p:spPr>
                <a:xfrm>
                  <a:off x="5706923" y="2812881"/>
                  <a:ext cx="0" cy="109770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Přímá spojnice se šipkou 79"/>
                <p:cNvCxnSpPr/>
                <p:nvPr/>
              </p:nvCxnSpPr>
              <p:spPr>
                <a:xfrm flipH="1">
                  <a:off x="5037051" y="1749964"/>
                  <a:ext cx="72538" cy="109770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Přímá spojnice se šipkou 81"/>
                <p:cNvCxnSpPr/>
                <p:nvPr/>
              </p:nvCxnSpPr>
              <p:spPr>
                <a:xfrm flipH="1">
                  <a:off x="5355249" y="2384685"/>
                  <a:ext cx="72538" cy="109770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Přímá spojnice se šipkou 82"/>
                <p:cNvCxnSpPr/>
                <p:nvPr/>
              </p:nvCxnSpPr>
              <p:spPr>
                <a:xfrm flipH="1">
                  <a:off x="5203437" y="2765620"/>
                  <a:ext cx="72538" cy="109770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Přímá spojnice se šipkou 83"/>
                <p:cNvCxnSpPr/>
                <p:nvPr/>
              </p:nvCxnSpPr>
              <p:spPr>
                <a:xfrm flipH="1">
                  <a:off x="5561353" y="2724515"/>
                  <a:ext cx="72538" cy="109770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2" name="Obrázek 1"/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26933" t="24470" r="33096" b="24078"/>
              <a:stretch/>
            </p:blipFill>
            <p:spPr>
              <a:xfrm>
                <a:off x="4867034" y="4002242"/>
                <a:ext cx="2606505" cy="2783958"/>
              </a:xfrm>
              <a:prstGeom prst="rect">
                <a:avLst/>
              </a:prstGeom>
            </p:spPr>
          </p:pic>
          <p:cxnSp>
            <p:nvCxnSpPr>
              <p:cNvPr id="7" name="Přímá spojnice se šipkou 6"/>
              <p:cNvCxnSpPr/>
              <p:nvPr/>
            </p:nvCxnSpPr>
            <p:spPr>
              <a:xfrm>
                <a:off x="6339092" y="4198513"/>
                <a:ext cx="0" cy="1202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Přímá spojnice se šipkou 63"/>
              <p:cNvCxnSpPr/>
              <p:nvPr/>
            </p:nvCxnSpPr>
            <p:spPr>
              <a:xfrm>
                <a:off x="6904173" y="5078640"/>
                <a:ext cx="0" cy="1202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Přímá spojnice se šipkou 11"/>
              <p:cNvCxnSpPr/>
              <p:nvPr/>
            </p:nvCxnSpPr>
            <p:spPr>
              <a:xfrm flipH="1">
                <a:off x="5594441" y="5078640"/>
                <a:ext cx="60510" cy="11520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Přímá spojnice se šipkou 68"/>
              <p:cNvCxnSpPr/>
              <p:nvPr/>
            </p:nvCxnSpPr>
            <p:spPr>
              <a:xfrm flipH="1">
                <a:off x="5903786" y="5739640"/>
                <a:ext cx="60510" cy="11520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Přímá spojnice se šipkou 70"/>
              <p:cNvCxnSpPr/>
              <p:nvPr/>
            </p:nvCxnSpPr>
            <p:spPr>
              <a:xfrm flipH="1">
                <a:off x="5805418" y="6177448"/>
                <a:ext cx="60510" cy="11520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Přímá spojnice se šipkou 80"/>
              <p:cNvCxnSpPr/>
              <p:nvPr/>
            </p:nvCxnSpPr>
            <p:spPr>
              <a:xfrm flipH="1">
                <a:off x="6163477" y="6099713"/>
                <a:ext cx="60510" cy="11520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Přímá spojnice se šipkou 88"/>
              <p:cNvCxnSpPr/>
              <p:nvPr/>
            </p:nvCxnSpPr>
            <p:spPr>
              <a:xfrm>
                <a:off x="6276422" y="6209294"/>
                <a:ext cx="71650" cy="13226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90" name="Zástupný symbol pro číslo snímku 89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F5404-1A97-4946-AED3-F51574ED3915}" type="slidenum">
              <a:rPr lang="cs-CZ" smtClean="0"/>
              <a:pPr/>
              <a:t>4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29503620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ovéPole 3"/>
          <p:cNvSpPr txBox="1"/>
          <p:nvPr/>
        </p:nvSpPr>
        <p:spPr>
          <a:xfrm>
            <a:off x="251520" y="583449"/>
            <a:ext cx="13179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r>
              <a:rPr lang="cs-CZ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cs-CZ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cs-CZ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ubiginosa</a:t>
            </a:r>
            <a:endParaRPr lang="cs-CZ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Skupina 4"/>
          <p:cNvGrpSpPr/>
          <p:nvPr/>
        </p:nvGrpSpPr>
        <p:grpSpPr>
          <a:xfrm>
            <a:off x="323528" y="980728"/>
            <a:ext cx="8568952" cy="5256584"/>
            <a:chOff x="604136" y="1194130"/>
            <a:chExt cx="8074119" cy="4784348"/>
          </a:xfrm>
        </p:grpSpPr>
        <p:grpSp>
          <p:nvGrpSpPr>
            <p:cNvPr id="30" name="Skupina 29"/>
            <p:cNvGrpSpPr/>
            <p:nvPr/>
          </p:nvGrpSpPr>
          <p:grpSpPr>
            <a:xfrm>
              <a:off x="3210452" y="1219219"/>
              <a:ext cx="2560197" cy="4644853"/>
              <a:chOff x="4280602" y="482625"/>
              <a:chExt cx="3413596" cy="6193137"/>
            </a:xfrm>
          </p:grpSpPr>
          <p:sp>
            <p:nvSpPr>
              <p:cNvPr id="6" name="TextovéPole 5"/>
              <p:cNvSpPr txBox="1"/>
              <p:nvPr/>
            </p:nvSpPr>
            <p:spPr>
              <a:xfrm>
                <a:off x="5398354" y="482625"/>
                <a:ext cx="1520075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900" dirty="0"/>
                  <a:t>R. rubiginosa_CZ_25</a:t>
                </a:r>
              </a:p>
            </p:txBody>
          </p:sp>
          <p:grpSp>
            <p:nvGrpSpPr>
              <p:cNvPr id="14" name="Skupina 13"/>
              <p:cNvGrpSpPr/>
              <p:nvPr/>
            </p:nvGrpSpPr>
            <p:grpSpPr>
              <a:xfrm>
                <a:off x="4280602" y="3612995"/>
                <a:ext cx="3345366" cy="3062767"/>
                <a:chOff x="4572000" y="3612995"/>
                <a:chExt cx="3345366" cy="3062767"/>
              </a:xfrm>
            </p:grpSpPr>
            <p:pic>
              <p:nvPicPr>
                <p:cNvPr id="2" name="Obrázek 1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BEBA8EAE-BF5A-486C-A8C5-ECC9F3942E4B}">
                      <a14:imgProps xmlns:a14="http://schemas.microsoft.com/office/drawing/2010/main" xmlns="">
                        <a14:imgLayer r:embed="rId3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16788" t="13008" r="21485" b="21788"/>
                <a:stretch/>
              </p:blipFill>
              <p:spPr>
                <a:xfrm>
                  <a:off x="4572000" y="3612995"/>
                  <a:ext cx="3345366" cy="3062767"/>
                </a:xfrm>
                <a:prstGeom prst="rect">
                  <a:avLst/>
                </a:prstGeom>
              </p:spPr>
            </p:pic>
            <p:cxnSp>
              <p:nvCxnSpPr>
                <p:cNvPr id="20" name="Přímá spojnice se šipkou 19"/>
                <p:cNvCxnSpPr/>
                <p:nvPr/>
              </p:nvCxnSpPr>
              <p:spPr>
                <a:xfrm>
                  <a:off x="5233358" y="4307457"/>
                  <a:ext cx="0" cy="132271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Přímá spojnice se šipkou 20"/>
                <p:cNvCxnSpPr/>
                <p:nvPr/>
              </p:nvCxnSpPr>
              <p:spPr>
                <a:xfrm>
                  <a:off x="5536820" y="4758906"/>
                  <a:ext cx="0" cy="132271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Přímá spojnice se šipkou 21"/>
                <p:cNvCxnSpPr/>
                <p:nvPr/>
              </p:nvCxnSpPr>
              <p:spPr>
                <a:xfrm>
                  <a:off x="6218307" y="4845170"/>
                  <a:ext cx="0" cy="132271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Přímá spojnice se šipkou 22"/>
                <p:cNvCxnSpPr/>
                <p:nvPr/>
              </p:nvCxnSpPr>
              <p:spPr>
                <a:xfrm>
                  <a:off x="5973888" y="5106839"/>
                  <a:ext cx="0" cy="132271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Přímá spojnice se šipkou 23"/>
                <p:cNvCxnSpPr/>
                <p:nvPr/>
              </p:nvCxnSpPr>
              <p:spPr>
                <a:xfrm flipH="1">
                  <a:off x="6459846" y="5627298"/>
                  <a:ext cx="90478" cy="92019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Přímá spojnice se šipkou 25"/>
                <p:cNvCxnSpPr/>
                <p:nvPr/>
              </p:nvCxnSpPr>
              <p:spPr>
                <a:xfrm flipH="1">
                  <a:off x="7342615" y="5911194"/>
                  <a:ext cx="90478" cy="92019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Přímá spojnice se šipkou 26"/>
                <p:cNvCxnSpPr/>
                <p:nvPr/>
              </p:nvCxnSpPr>
              <p:spPr>
                <a:xfrm flipH="1">
                  <a:off x="7332651" y="5144378"/>
                  <a:ext cx="9964" cy="12613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9" name="Obrázek 8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 xmlns="">
                      <a14:imgLayer r:embed="rId5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2199" t="13333" r="23034" b="20000"/>
              <a:stretch/>
            </p:blipFill>
            <p:spPr>
              <a:xfrm>
                <a:off x="4326064" y="734224"/>
                <a:ext cx="3368134" cy="3004904"/>
              </a:xfrm>
              <a:prstGeom prst="rect">
                <a:avLst/>
              </a:prstGeom>
            </p:spPr>
          </p:pic>
          <p:cxnSp>
            <p:nvCxnSpPr>
              <p:cNvPr id="25" name="Přímá spojnice se šipkou 24"/>
              <p:cNvCxnSpPr/>
              <p:nvPr/>
            </p:nvCxnSpPr>
            <p:spPr>
              <a:xfrm>
                <a:off x="5007077" y="1268083"/>
                <a:ext cx="7375" cy="9614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Přímá spojnice se šipkou 35"/>
              <p:cNvCxnSpPr/>
              <p:nvPr/>
            </p:nvCxnSpPr>
            <p:spPr>
              <a:xfrm>
                <a:off x="5277464" y="1715452"/>
                <a:ext cx="7375" cy="9614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Přímá spojnice se šipkou 39"/>
              <p:cNvCxnSpPr/>
              <p:nvPr/>
            </p:nvCxnSpPr>
            <p:spPr>
              <a:xfrm>
                <a:off x="5931309" y="1816234"/>
                <a:ext cx="7375" cy="9614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Přímá spojnice se šipkou 42"/>
              <p:cNvCxnSpPr/>
              <p:nvPr/>
            </p:nvCxnSpPr>
            <p:spPr>
              <a:xfrm>
                <a:off x="5700251" y="2064496"/>
                <a:ext cx="7375" cy="9614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Přímá spojnice se šipkou 43"/>
              <p:cNvCxnSpPr/>
              <p:nvPr/>
            </p:nvCxnSpPr>
            <p:spPr>
              <a:xfrm>
                <a:off x="7003023" y="2098909"/>
                <a:ext cx="7375" cy="9614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Přímá spojnice se šipkou 44"/>
              <p:cNvCxnSpPr/>
              <p:nvPr/>
            </p:nvCxnSpPr>
            <p:spPr>
              <a:xfrm flipH="1">
                <a:off x="6189404" y="2548730"/>
                <a:ext cx="54774" cy="78938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Přímá spojnice se šipkou 45"/>
              <p:cNvCxnSpPr/>
              <p:nvPr/>
            </p:nvCxnSpPr>
            <p:spPr>
              <a:xfrm flipH="1">
                <a:off x="7042354" y="2841239"/>
                <a:ext cx="54774" cy="78938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7" name="Skupina 56"/>
            <p:cNvGrpSpPr/>
            <p:nvPr/>
          </p:nvGrpSpPr>
          <p:grpSpPr>
            <a:xfrm>
              <a:off x="6181414" y="1219219"/>
              <a:ext cx="2496841" cy="4644087"/>
              <a:chOff x="8241885" y="482625"/>
              <a:chExt cx="3329121" cy="6192116"/>
            </a:xfrm>
          </p:grpSpPr>
          <p:pic>
            <p:nvPicPr>
              <p:cNvPr id="10" name="Obrázek 9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 xmlns="">
                      <a14:imgLayer r:embed="rId7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1841" t="10040" r="14741" b="12784"/>
              <a:stretch/>
            </p:blipFill>
            <p:spPr>
              <a:xfrm>
                <a:off x="8241885" y="734224"/>
                <a:ext cx="3329121" cy="3033200"/>
              </a:xfrm>
              <a:prstGeom prst="rect">
                <a:avLst/>
              </a:prstGeom>
            </p:spPr>
          </p:pic>
          <p:sp>
            <p:nvSpPr>
              <p:cNvPr id="11" name="TextovéPole 10"/>
              <p:cNvSpPr txBox="1"/>
              <p:nvPr/>
            </p:nvSpPr>
            <p:spPr>
              <a:xfrm>
                <a:off x="9258326" y="482625"/>
                <a:ext cx="1520075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900" dirty="0"/>
                  <a:t>R. rubiginosa_CZ_38</a:t>
                </a:r>
              </a:p>
            </p:txBody>
          </p:sp>
          <p:cxnSp>
            <p:nvCxnSpPr>
              <p:cNvPr id="34" name="Přímá spojnice se šipkou 33"/>
              <p:cNvCxnSpPr/>
              <p:nvPr/>
            </p:nvCxnSpPr>
            <p:spPr>
              <a:xfrm flipH="1">
                <a:off x="9437298" y="1926566"/>
                <a:ext cx="86264" cy="11501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Přímá spojnice se šipkou 34"/>
              <p:cNvCxnSpPr/>
              <p:nvPr/>
            </p:nvCxnSpPr>
            <p:spPr>
              <a:xfrm flipH="1">
                <a:off x="8962845" y="1155940"/>
                <a:ext cx="8627" cy="11214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Přímá spojnice se šipkou 36"/>
              <p:cNvCxnSpPr/>
              <p:nvPr/>
            </p:nvCxnSpPr>
            <p:spPr>
              <a:xfrm flipH="1">
                <a:off x="10179170" y="2654061"/>
                <a:ext cx="8627" cy="11214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Přímá spojnice se šipkou 37"/>
              <p:cNvCxnSpPr/>
              <p:nvPr/>
            </p:nvCxnSpPr>
            <p:spPr>
              <a:xfrm flipH="1">
                <a:off x="11010182" y="2541918"/>
                <a:ext cx="8627" cy="11214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Přímá spojnice se šipkou 38"/>
              <p:cNvCxnSpPr/>
              <p:nvPr/>
            </p:nvCxnSpPr>
            <p:spPr>
              <a:xfrm flipH="1">
                <a:off x="10777269" y="2872597"/>
                <a:ext cx="8627" cy="11214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Přímá spojnice se šipkou 40"/>
              <p:cNvCxnSpPr/>
              <p:nvPr/>
            </p:nvCxnSpPr>
            <p:spPr>
              <a:xfrm flipV="1">
                <a:off x="10598989" y="3462068"/>
                <a:ext cx="0" cy="12792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Přímá spojnice se šipkou 41"/>
              <p:cNvCxnSpPr/>
              <p:nvPr/>
            </p:nvCxnSpPr>
            <p:spPr>
              <a:xfrm flipH="1">
                <a:off x="9172062" y="1534314"/>
                <a:ext cx="86264" cy="11501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7" name="Obrázek 6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BEBA8EAE-BF5A-486C-A8C5-ECC9F3942E4B}">
                    <a14:imgProps xmlns:a14="http://schemas.microsoft.com/office/drawing/2010/main" xmlns="">
                      <a14:imgLayer r:embed="rId9">
                        <a14:imgEffect>
                          <a14:brightnessContrast contrast="-3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8623" t="8583" r="19111" b="15110"/>
              <a:stretch/>
            </p:blipFill>
            <p:spPr>
              <a:xfrm>
                <a:off x="8391943" y="3828738"/>
                <a:ext cx="3109665" cy="2846003"/>
              </a:xfrm>
              <a:prstGeom prst="rect">
                <a:avLst/>
              </a:prstGeom>
            </p:spPr>
          </p:pic>
          <p:cxnSp>
            <p:nvCxnSpPr>
              <p:cNvPr id="32" name="Přímá spojnice se šipkou 31"/>
              <p:cNvCxnSpPr/>
              <p:nvPr/>
            </p:nvCxnSpPr>
            <p:spPr>
              <a:xfrm>
                <a:off x="8981505" y="4085213"/>
                <a:ext cx="0" cy="13304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Přímá spojnice se šipkou 46"/>
              <p:cNvCxnSpPr/>
              <p:nvPr/>
            </p:nvCxnSpPr>
            <p:spPr>
              <a:xfrm flipH="1">
                <a:off x="9204689" y="4439728"/>
                <a:ext cx="53637" cy="14383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Přímá spojnice se šipkou 47"/>
              <p:cNvCxnSpPr/>
              <p:nvPr/>
            </p:nvCxnSpPr>
            <p:spPr>
              <a:xfrm flipH="1">
                <a:off x="9444169" y="4863830"/>
                <a:ext cx="104273" cy="11472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Přímá spojnice se šipkou 50"/>
              <p:cNvCxnSpPr/>
              <p:nvPr/>
            </p:nvCxnSpPr>
            <p:spPr>
              <a:xfrm>
                <a:off x="10172707" y="5512795"/>
                <a:ext cx="0" cy="13304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Přímá spojnice se šipkou 51"/>
              <p:cNvCxnSpPr/>
              <p:nvPr/>
            </p:nvCxnSpPr>
            <p:spPr>
              <a:xfrm>
                <a:off x="10947147" y="5372841"/>
                <a:ext cx="0" cy="13304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Přímá spojnice se šipkou 52"/>
              <p:cNvCxnSpPr/>
              <p:nvPr/>
            </p:nvCxnSpPr>
            <p:spPr>
              <a:xfrm>
                <a:off x="10720105" y="5718066"/>
                <a:ext cx="0" cy="13304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Přímá spojnice se šipkou 53"/>
              <p:cNvCxnSpPr/>
              <p:nvPr/>
            </p:nvCxnSpPr>
            <p:spPr>
              <a:xfrm flipH="1" flipV="1">
                <a:off x="10586368" y="6252326"/>
                <a:ext cx="12621" cy="12981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6" name="Skupina 75"/>
            <p:cNvGrpSpPr/>
            <p:nvPr/>
          </p:nvGrpSpPr>
          <p:grpSpPr>
            <a:xfrm>
              <a:off x="604136" y="1194130"/>
              <a:ext cx="2273958" cy="4784348"/>
              <a:chOff x="805514" y="449173"/>
              <a:chExt cx="3031944" cy="6379130"/>
            </a:xfrm>
          </p:grpSpPr>
          <p:sp>
            <p:nvSpPr>
              <p:cNvPr id="3" name="TextovéPole 2"/>
              <p:cNvSpPr txBox="1"/>
              <p:nvPr/>
            </p:nvSpPr>
            <p:spPr>
              <a:xfrm>
                <a:off x="1639586" y="449173"/>
                <a:ext cx="1520075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cs-CZ" sz="900" dirty="0"/>
                  <a:t>R. rubiginosa_CZ_29</a:t>
                </a:r>
              </a:p>
            </p:txBody>
          </p:sp>
          <p:pic>
            <p:nvPicPr>
              <p:cNvPr id="58" name="Obrázek 57"/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5535" t="9435" r="20136" b="9694"/>
              <a:stretch/>
            </p:blipFill>
            <p:spPr>
              <a:xfrm>
                <a:off x="930299" y="3917379"/>
                <a:ext cx="2671564" cy="2910924"/>
              </a:xfrm>
              <a:prstGeom prst="rect">
                <a:avLst/>
              </a:prstGeom>
            </p:spPr>
          </p:pic>
          <p:pic>
            <p:nvPicPr>
              <p:cNvPr id="59" name="Obrázek 58"/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BEBA8EAE-BF5A-486C-A8C5-ECC9F3942E4B}">
                    <a14:imgProps xmlns:a14="http://schemas.microsoft.com/office/drawing/2010/main" xmlns="">
                      <a14:imgLayer r:embed="rId12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1841" t="5333" r="18140" b="9177"/>
              <a:stretch/>
            </p:blipFill>
            <p:spPr>
              <a:xfrm>
                <a:off x="805514" y="687300"/>
                <a:ext cx="3031944" cy="3208563"/>
              </a:xfrm>
              <a:prstGeom prst="rect">
                <a:avLst/>
              </a:prstGeom>
            </p:spPr>
          </p:pic>
          <p:cxnSp>
            <p:nvCxnSpPr>
              <p:cNvPr id="61" name="Přímá spojnice se šipkou 60"/>
              <p:cNvCxnSpPr/>
              <p:nvPr/>
            </p:nvCxnSpPr>
            <p:spPr>
              <a:xfrm>
                <a:off x="1900844" y="4151734"/>
                <a:ext cx="0" cy="15572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Přímá spojnice se šipkou 61"/>
              <p:cNvCxnSpPr/>
              <p:nvPr/>
            </p:nvCxnSpPr>
            <p:spPr>
              <a:xfrm>
                <a:off x="1675609" y="4404619"/>
                <a:ext cx="0" cy="15572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Přímá spojnice se šipkou 62"/>
              <p:cNvCxnSpPr/>
              <p:nvPr/>
            </p:nvCxnSpPr>
            <p:spPr>
              <a:xfrm>
                <a:off x="2249190" y="4817483"/>
                <a:ext cx="0" cy="15572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Přímá spojnice se šipkou 63"/>
              <p:cNvCxnSpPr/>
              <p:nvPr/>
            </p:nvCxnSpPr>
            <p:spPr>
              <a:xfrm>
                <a:off x="1991493" y="4831333"/>
                <a:ext cx="0" cy="15572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Přímá spojnice se šipkou 64"/>
              <p:cNvCxnSpPr/>
              <p:nvPr/>
            </p:nvCxnSpPr>
            <p:spPr>
              <a:xfrm>
                <a:off x="1656213" y="5488042"/>
                <a:ext cx="0" cy="15572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Přímá spojnice se šipkou 65"/>
              <p:cNvCxnSpPr/>
              <p:nvPr/>
            </p:nvCxnSpPr>
            <p:spPr>
              <a:xfrm>
                <a:off x="1936077" y="5352268"/>
                <a:ext cx="0" cy="15572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Přímá spojnice se šipkou 66"/>
              <p:cNvCxnSpPr/>
              <p:nvPr/>
            </p:nvCxnSpPr>
            <p:spPr>
              <a:xfrm>
                <a:off x="2071851" y="5476958"/>
                <a:ext cx="0" cy="155723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Přímá spojnice se šipkou 68"/>
              <p:cNvCxnSpPr/>
              <p:nvPr/>
            </p:nvCxnSpPr>
            <p:spPr>
              <a:xfrm>
                <a:off x="1878676" y="1019696"/>
                <a:ext cx="0" cy="127461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Přímá spojnice se šipkou 69"/>
              <p:cNvCxnSpPr/>
              <p:nvPr/>
            </p:nvCxnSpPr>
            <p:spPr>
              <a:xfrm>
                <a:off x="1992282" y="1731821"/>
                <a:ext cx="0" cy="127461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Přímá spojnice se šipkou 70"/>
              <p:cNvCxnSpPr/>
              <p:nvPr/>
            </p:nvCxnSpPr>
            <p:spPr>
              <a:xfrm>
                <a:off x="1657002" y="1296791"/>
                <a:ext cx="0" cy="127461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Přímá spojnice se šipkou 71"/>
              <p:cNvCxnSpPr/>
              <p:nvPr/>
            </p:nvCxnSpPr>
            <p:spPr>
              <a:xfrm>
                <a:off x="1620980" y="2441180"/>
                <a:ext cx="0" cy="127461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Přímá spojnice se šipkou 72"/>
              <p:cNvCxnSpPr/>
              <p:nvPr/>
            </p:nvCxnSpPr>
            <p:spPr>
              <a:xfrm>
                <a:off x="1928554" y="2299866"/>
                <a:ext cx="0" cy="127461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Přímá spojnice se šipkou 73"/>
              <p:cNvCxnSpPr/>
              <p:nvPr/>
            </p:nvCxnSpPr>
            <p:spPr>
              <a:xfrm>
                <a:off x="2058786" y="2391305"/>
                <a:ext cx="0" cy="127461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Přímá spojnice se šipkou 74"/>
              <p:cNvCxnSpPr/>
              <p:nvPr/>
            </p:nvCxnSpPr>
            <p:spPr>
              <a:xfrm>
                <a:off x="2238895" y="1734590"/>
                <a:ext cx="0" cy="127461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60" name="Zástupný symbol pro číslo snímku 59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F5404-1A97-4946-AED3-F51574ED3915}" type="slidenum">
              <a:rPr lang="cs-CZ" smtClean="0"/>
              <a:pPr/>
              <a:t>5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xmlns="" val="34881734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iv sady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36</TotalTime>
  <Words>128</Words>
  <Application>Microsoft Office PowerPoint</Application>
  <PresentationFormat>Předvádění na obrazovce (4:3)</PresentationFormat>
  <Paragraphs>27</Paragraphs>
  <Slides>5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5</vt:i4>
      </vt:variant>
    </vt:vector>
  </HeadingPairs>
  <TitlesOfParts>
    <vt:vector size="6" baseType="lpstr">
      <vt:lpstr>Motiv systému Office</vt:lpstr>
      <vt:lpstr>Snímek 1</vt:lpstr>
      <vt:lpstr>Snímek 2</vt:lpstr>
      <vt:lpstr>Snímek 3</vt:lpstr>
      <vt:lpstr>Snímek 4</vt:lpstr>
      <vt:lpstr>Snímek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Ales Kovarik</dc:creator>
  <cp:lastModifiedBy>kovarik</cp:lastModifiedBy>
  <cp:revision>306</cp:revision>
  <cp:lastPrinted>2019-01-24T10:53:01Z</cp:lastPrinted>
  <dcterms:created xsi:type="dcterms:W3CDTF">2018-07-26T06:09:56Z</dcterms:created>
  <dcterms:modified xsi:type="dcterms:W3CDTF">2020-01-15T13:16:47Z</dcterms:modified>
</cp:coreProperties>
</file>